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bookmarkIdSeed="13">
  <p:sldMasterIdLst>
    <p:sldMasterId id="2147483660" r:id="rId1"/>
  </p:sldMasterIdLst>
  <p:notesMasterIdLst>
    <p:notesMasterId r:id="rId61"/>
  </p:notesMasterIdLst>
  <p:handoutMasterIdLst>
    <p:handoutMasterId r:id="rId62"/>
  </p:handoutMasterIdLst>
  <p:sldIdLst>
    <p:sldId id="256" r:id="rId2"/>
    <p:sldId id="337" r:id="rId3"/>
    <p:sldId id="360" r:id="rId4"/>
    <p:sldId id="361" r:id="rId5"/>
    <p:sldId id="356" r:id="rId6"/>
    <p:sldId id="357" r:id="rId7"/>
    <p:sldId id="358" r:id="rId8"/>
    <p:sldId id="359" r:id="rId9"/>
    <p:sldId id="350" r:id="rId10"/>
    <p:sldId id="353" r:id="rId11"/>
    <p:sldId id="352" r:id="rId12"/>
    <p:sldId id="354" r:id="rId13"/>
    <p:sldId id="355" r:id="rId14"/>
    <p:sldId id="322" r:id="rId15"/>
    <p:sldId id="328" r:id="rId16"/>
    <p:sldId id="331" r:id="rId17"/>
    <p:sldId id="327" r:id="rId18"/>
    <p:sldId id="332" r:id="rId19"/>
    <p:sldId id="323" r:id="rId20"/>
    <p:sldId id="324" r:id="rId21"/>
    <p:sldId id="325" r:id="rId22"/>
    <p:sldId id="326" r:id="rId23"/>
    <p:sldId id="333" r:id="rId24"/>
    <p:sldId id="334" r:id="rId25"/>
    <p:sldId id="329" r:id="rId26"/>
    <p:sldId id="330" r:id="rId27"/>
    <p:sldId id="364" r:id="rId28"/>
    <p:sldId id="363" r:id="rId29"/>
    <p:sldId id="277" r:id="rId30"/>
    <p:sldId id="278" r:id="rId31"/>
    <p:sldId id="279" r:id="rId32"/>
    <p:sldId id="280" r:id="rId33"/>
    <p:sldId id="281" r:id="rId34"/>
    <p:sldId id="282" r:id="rId35"/>
    <p:sldId id="373" r:id="rId36"/>
    <p:sldId id="283" r:id="rId37"/>
    <p:sldId id="284" r:id="rId38"/>
    <p:sldId id="285" r:id="rId39"/>
    <p:sldId id="286" r:id="rId40"/>
    <p:sldId id="366" r:id="rId41"/>
    <p:sldId id="287" r:id="rId42"/>
    <p:sldId id="288" r:id="rId43"/>
    <p:sldId id="289" r:id="rId44"/>
    <p:sldId id="368" r:id="rId45"/>
    <p:sldId id="290" r:id="rId46"/>
    <p:sldId id="291" r:id="rId47"/>
    <p:sldId id="292" r:id="rId48"/>
    <p:sldId id="369" r:id="rId49"/>
    <p:sldId id="293" r:id="rId50"/>
    <p:sldId id="294" r:id="rId51"/>
    <p:sldId id="295" r:id="rId52"/>
    <p:sldId id="296" r:id="rId53"/>
    <p:sldId id="297" r:id="rId54"/>
    <p:sldId id="370" r:id="rId55"/>
    <p:sldId id="298" r:id="rId56"/>
    <p:sldId id="299" r:id="rId57"/>
    <p:sldId id="371" r:id="rId58"/>
    <p:sldId id="300" r:id="rId59"/>
    <p:sldId id="372" r:id="rId6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40" autoAdjust="0"/>
    <p:restoredTop sz="93677" autoAdjust="0"/>
  </p:normalViewPr>
  <p:slideViewPr>
    <p:cSldViewPr snapToGrid="0">
      <p:cViewPr>
        <p:scale>
          <a:sx n="80" d="100"/>
          <a:sy n="80" d="100"/>
        </p:scale>
        <p:origin x="1866" y="-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presProps" Target="presProp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tableStyles" Target="tableStyles.xml"/><Relationship Id="rId5" Type="http://schemas.openxmlformats.org/officeDocument/2006/relationships/slide" Target="slides/slide4.xml"/><Relationship Id="rId61" Type="http://schemas.openxmlformats.org/officeDocument/2006/relationships/notesMaster" Target="notesMasters/notesMaster1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viewProps" Target="viewProp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w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w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9.e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8.vml.rels><?xml version="1.0" encoding="UTF-8" standalone="yes"?>
<Relationships xmlns="http://schemas.openxmlformats.org/package/2006/relationships"><Relationship Id="rId1" Type="http://schemas.openxmlformats.org/officeDocument/2006/relationships/image" Target="../media/image30.emf"/></Relationships>
</file>

<file path=ppt/drawings/_rels/vmlDrawing19.vml.rels><?xml version="1.0" encoding="UTF-8" standalone="yes"?>
<Relationships xmlns="http://schemas.openxmlformats.org/package/2006/relationships"><Relationship Id="rId1" Type="http://schemas.openxmlformats.org/officeDocument/2006/relationships/image" Target="../media/image4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20.vml.rels><?xml version="1.0" encoding="UTF-8" standalone="yes"?>
<Relationships xmlns="http://schemas.openxmlformats.org/package/2006/relationships"><Relationship Id="rId1" Type="http://schemas.openxmlformats.org/officeDocument/2006/relationships/image" Target="../media/image45.emf"/></Relationships>
</file>

<file path=ppt/drawings/_rels/vmlDrawing2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5.emf"/></Relationships>
</file>

<file path=ppt/drawings/_rels/vmlDrawing2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5.emf"/></Relationships>
</file>

<file path=ppt/drawings/_rels/vmlDrawing2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5.emf"/></Relationships>
</file>

<file path=ppt/drawings/_rels/vmlDrawing24.vml.rels><?xml version="1.0" encoding="UTF-8" standalone="yes"?>
<Relationships xmlns="http://schemas.openxmlformats.org/package/2006/relationships"><Relationship Id="rId1" Type="http://schemas.openxmlformats.org/officeDocument/2006/relationships/image" Target="../media/image53.emf"/></Relationships>
</file>

<file path=ppt/drawings/_rels/vmlDrawing25.vml.rels><?xml version="1.0" encoding="UTF-8" standalone="yes"?>
<Relationships xmlns="http://schemas.openxmlformats.org/package/2006/relationships"><Relationship Id="rId1" Type="http://schemas.openxmlformats.org/officeDocument/2006/relationships/image" Target="../media/image55.emf"/></Relationships>
</file>

<file path=ppt/drawings/_rels/vmlDrawing26.vml.rels><?xml version="1.0" encoding="UTF-8" standalone="yes"?>
<Relationships xmlns="http://schemas.openxmlformats.org/package/2006/relationships"><Relationship Id="rId1" Type="http://schemas.openxmlformats.org/officeDocument/2006/relationships/image" Target="../media/image55.emf"/></Relationships>
</file>

<file path=ppt/drawings/_rels/vmlDrawing27.vml.rels><?xml version="1.0" encoding="UTF-8" standalone="yes"?>
<Relationships xmlns="http://schemas.openxmlformats.org/package/2006/relationships"><Relationship Id="rId1" Type="http://schemas.openxmlformats.org/officeDocument/2006/relationships/image" Target="../media/image55.emf"/></Relationships>
</file>

<file path=ppt/drawings/_rels/vmlDrawing28.vml.rels><?xml version="1.0" encoding="UTF-8" standalone="yes"?>
<Relationships xmlns="http://schemas.openxmlformats.org/package/2006/relationships"><Relationship Id="rId1" Type="http://schemas.openxmlformats.org/officeDocument/2006/relationships/image" Target="../media/image62.emf"/></Relationships>
</file>

<file path=ppt/drawings/_rels/vmlDrawing29.vml.rels><?xml version="1.0" encoding="UTF-8" standalone="yes"?>
<Relationships xmlns="http://schemas.openxmlformats.org/package/2006/relationships"><Relationship Id="rId1" Type="http://schemas.openxmlformats.org/officeDocument/2006/relationships/image" Target="../media/image64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30.vml.rels><?xml version="1.0" encoding="UTF-8" standalone="yes"?>
<Relationships xmlns="http://schemas.openxmlformats.org/package/2006/relationships"><Relationship Id="rId1" Type="http://schemas.openxmlformats.org/officeDocument/2006/relationships/image" Target="../media/image64.emf"/></Relationships>
</file>

<file path=ppt/drawings/_rels/vmlDrawing3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9.emf"/></Relationships>
</file>

<file path=ppt/drawings/_rels/vmlDrawing3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2.emf"/></Relationships>
</file>

<file path=ppt/drawings/_rels/vmlDrawing33.vml.rels><?xml version="1.0" encoding="UTF-8" standalone="yes"?>
<Relationships xmlns="http://schemas.openxmlformats.org/package/2006/relationships"><Relationship Id="rId1" Type="http://schemas.openxmlformats.org/officeDocument/2006/relationships/image" Target="../media/image74.emf"/></Relationships>
</file>

<file path=ppt/drawings/_rels/vmlDrawing3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4.emf"/></Relationships>
</file>

<file path=ppt/drawings/_rels/vmlDrawing35.vml.rels><?xml version="1.0" encoding="UTF-8" standalone="yes"?>
<Relationships xmlns="http://schemas.openxmlformats.org/package/2006/relationships"><Relationship Id="rId1" Type="http://schemas.openxmlformats.org/officeDocument/2006/relationships/image" Target="../media/image74.emf"/></Relationships>
</file>

<file path=ppt/drawings/_rels/vmlDrawing36.vml.rels><?xml version="1.0" encoding="UTF-8" standalone="yes"?>
<Relationships xmlns="http://schemas.openxmlformats.org/package/2006/relationships"><Relationship Id="rId1" Type="http://schemas.openxmlformats.org/officeDocument/2006/relationships/image" Target="../media/image74.emf"/></Relationships>
</file>

<file path=ppt/drawings/_rels/vmlDrawing37.vml.rels><?xml version="1.0" encoding="UTF-8" standalone="yes"?>
<Relationships xmlns="http://schemas.openxmlformats.org/package/2006/relationships"><Relationship Id="rId1" Type="http://schemas.openxmlformats.org/officeDocument/2006/relationships/image" Target="../media/image74.emf"/></Relationships>
</file>

<file path=ppt/drawings/_rels/vmlDrawing38.vml.rels><?xml version="1.0" encoding="UTF-8" standalone="yes"?>
<Relationships xmlns="http://schemas.openxmlformats.org/package/2006/relationships"><Relationship Id="rId1" Type="http://schemas.openxmlformats.org/officeDocument/2006/relationships/image" Target="../media/image83.emf"/></Relationships>
</file>

<file path=ppt/drawings/_rels/vmlDrawing39.vml.rels><?xml version="1.0" encoding="UTF-8" standalone="yes"?>
<Relationships xmlns="http://schemas.openxmlformats.org/package/2006/relationships"><Relationship Id="rId1" Type="http://schemas.openxmlformats.org/officeDocument/2006/relationships/image" Target="../media/image8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wmf"/></Relationships>
</file>

<file path=ppt/drawings/_rels/vmlDrawing40.vml.rels><?xml version="1.0" encoding="UTF-8" standalone="yes"?>
<Relationships xmlns="http://schemas.openxmlformats.org/package/2006/relationships"><Relationship Id="rId1" Type="http://schemas.openxmlformats.org/officeDocument/2006/relationships/image" Target="../media/image85.emf"/></Relationships>
</file>

<file path=ppt/drawings/_rels/vmlDrawing41.vml.rels><?xml version="1.0" encoding="UTF-8" standalone="yes"?>
<Relationships xmlns="http://schemas.openxmlformats.org/package/2006/relationships"><Relationship Id="rId1" Type="http://schemas.openxmlformats.org/officeDocument/2006/relationships/image" Target="../media/image90.emf"/></Relationships>
</file>

<file path=ppt/drawings/_rels/vmlDrawing4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2.emf"/></Relationships>
</file>

<file path=ppt/drawings/_rels/vmlDrawing43.vml.rels><?xml version="1.0" encoding="UTF-8" standalone="yes"?>
<Relationships xmlns="http://schemas.openxmlformats.org/package/2006/relationships"><Relationship Id="rId1" Type="http://schemas.openxmlformats.org/officeDocument/2006/relationships/image" Target="../media/image95.e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w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w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w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w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507F7B-4188-4485-9B83-49EEA704FEEA}" type="datetimeFigureOut">
              <a:rPr lang="en-US" smtClean="0"/>
              <a:t>2/2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81621A-85D5-42F2-A020-1B0F68A2A5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157154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673163-A30A-41EA-BD08-03465DFDD86B}" type="datetimeFigureOut">
              <a:rPr lang="en-US" smtClean="0"/>
              <a:t>2/2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84BA0B-A90A-477E-867D-C319DB3156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553891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AA93-B79D-49ED-9489-733868005063}" type="datetime1">
              <a:rPr lang="en-US" smtClean="0"/>
              <a:t>2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0884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EF2A5-8511-429A-B2DF-6D7EC458E677}" type="datetime1">
              <a:rPr lang="en-US" smtClean="0"/>
              <a:t>2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306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32F8B-F2BB-443E-87FC-13B8D6DCB085}" type="datetime1">
              <a:rPr lang="en-US" smtClean="0"/>
              <a:t>2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3171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31BF2-7AED-4481-8D96-A869DA9782A7}" type="datetime1">
              <a:rPr lang="en-US" smtClean="0"/>
              <a:t>2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158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A0CBFB-861E-438E-BC05-0DE6B2C5842D}" type="datetime1">
              <a:rPr lang="en-US" smtClean="0"/>
              <a:t>2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9574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2AA38-6A13-4F68-8D02-7F96E2A5B132}" type="datetime1">
              <a:rPr lang="en-US" smtClean="0"/>
              <a:t>2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138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EE015-FDF1-434A-95F1-6FC7D951CD92}" type="datetime1">
              <a:rPr lang="en-US" smtClean="0"/>
              <a:t>2/2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679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87C0D3-2520-4F68-AFC8-17F1AA4D2689}" type="datetime1">
              <a:rPr lang="en-US" smtClean="0"/>
              <a:t>2/2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499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66BA1D-7E9F-4E02-B19B-49A2BBF15BB8}" type="datetime1">
              <a:rPr lang="en-US" smtClean="0"/>
              <a:t>2/2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142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14441C-57D8-490C-A08B-24A7B2455538}" type="datetime1">
              <a:rPr lang="en-US" smtClean="0"/>
              <a:t>2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234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63697C-01A7-4EFA-A467-C4F432054B8F}" type="datetime1">
              <a:rPr lang="en-US" smtClean="0"/>
              <a:t>2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1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7977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5C70F5-B8CF-453A-9823-7977881943B6}" type="datetime1">
              <a:rPr lang="en-US" smtClean="0"/>
              <a:t>2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S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1B916-522C-4F6F-9F58-8C8ABA027C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9798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3.wmf"/><Relationship Id="rId4" Type="http://schemas.openxmlformats.org/officeDocument/2006/relationships/oleObject" Target="../embeddings/oleObject2.bin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5.wmf"/><Relationship Id="rId4" Type="http://schemas.openxmlformats.org/officeDocument/2006/relationships/oleObject" Target="../embeddings/oleObject3.bin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5" Type="http://schemas.openxmlformats.org/officeDocument/2006/relationships/image" Target="../media/image7.wmf"/><Relationship Id="rId4" Type="http://schemas.openxmlformats.org/officeDocument/2006/relationships/oleObject" Target="../embeddings/oleObject4.bin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5" Type="http://schemas.openxmlformats.org/officeDocument/2006/relationships/image" Target="../media/image9.wmf"/><Relationship Id="rId4" Type="http://schemas.openxmlformats.org/officeDocument/2006/relationships/oleObject" Target="../embeddings/oleObject5.bin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6.vml"/><Relationship Id="rId5" Type="http://schemas.openxmlformats.org/officeDocument/2006/relationships/image" Target="../media/image11.wmf"/><Relationship Id="rId4" Type="http://schemas.openxmlformats.org/officeDocument/2006/relationships/oleObject" Target="../embeddings/oleObject6.bin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5" Type="http://schemas.openxmlformats.org/officeDocument/2006/relationships/image" Target="../media/image13.wmf"/><Relationship Id="rId4" Type="http://schemas.openxmlformats.org/officeDocument/2006/relationships/oleObject" Target="../embeddings/oleObject7.bin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8.vml"/><Relationship Id="rId5" Type="http://schemas.openxmlformats.org/officeDocument/2006/relationships/image" Target="../media/image19.wmf"/><Relationship Id="rId4" Type="http://schemas.openxmlformats.org/officeDocument/2006/relationships/oleObject" Target="../embeddings/oleObject8.bin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9.vml"/><Relationship Id="rId5" Type="http://schemas.openxmlformats.org/officeDocument/2006/relationships/image" Target="../media/image21.wmf"/><Relationship Id="rId4" Type="http://schemas.openxmlformats.org/officeDocument/2006/relationships/oleObject" Target="../embeddings/oleObject9.bin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0.vml"/><Relationship Id="rId5" Type="http://schemas.openxmlformats.org/officeDocument/2006/relationships/image" Target="../media/image23.wmf"/><Relationship Id="rId4" Type="http://schemas.openxmlformats.org/officeDocument/2006/relationships/oleObject" Target="../embeddings/oleObject10.bin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1.vml"/><Relationship Id="rId5" Type="http://schemas.openxmlformats.org/officeDocument/2006/relationships/image" Target="../media/image25.wmf"/><Relationship Id="rId4" Type="http://schemas.openxmlformats.org/officeDocument/2006/relationships/oleObject" Target="../embeddings/oleObject11.bin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2.vml"/><Relationship Id="rId4" Type="http://schemas.openxmlformats.org/officeDocument/2006/relationships/image" Target="../media/image29.emf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3.vml"/><Relationship Id="rId6" Type="http://schemas.openxmlformats.org/officeDocument/2006/relationships/image" Target="../media/image32.jpeg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3.bin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4.vml"/><Relationship Id="rId6" Type="http://schemas.openxmlformats.org/officeDocument/2006/relationships/image" Target="../media/image34.jpeg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4.bin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5.vml"/><Relationship Id="rId6" Type="http://schemas.openxmlformats.org/officeDocument/2006/relationships/image" Target="../media/image36.jpeg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5.bin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6.vml"/><Relationship Id="rId6" Type="http://schemas.openxmlformats.org/officeDocument/2006/relationships/image" Target="../media/image38.jpeg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6.bin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7.vml"/><Relationship Id="rId6" Type="http://schemas.openxmlformats.org/officeDocument/2006/relationships/image" Target="../media/image40.jpeg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7.bin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8.vml"/><Relationship Id="rId6" Type="http://schemas.openxmlformats.org/officeDocument/2006/relationships/image" Target="../media/image42.jpeg"/><Relationship Id="rId5" Type="http://schemas.openxmlformats.org/officeDocument/2006/relationships/image" Target="../media/image30.emf"/><Relationship Id="rId4" Type="http://schemas.openxmlformats.org/officeDocument/2006/relationships/oleObject" Target="../embeddings/oleObject18.bin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9.vml"/><Relationship Id="rId5" Type="http://schemas.openxmlformats.org/officeDocument/2006/relationships/image" Target="../media/image44.emf"/><Relationship Id="rId4" Type="http://schemas.openxmlformats.org/officeDocument/2006/relationships/image" Target="../media/image43.emf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0.vml"/><Relationship Id="rId6" Type="http://schemas.openxmlformats.org/officeDocument/2006/relationships/image" Target="../media/image47.jpeg"/><Relationship Id="rId5" Type="http://schemas.openxmlformats.org/officeDocument/2006/relationships/image" Target="../media/image45.emf"/><Relationship Id="rId4" Type="http://schemas.openxmlformats.org/officeDocument/2006/relationships/oleObject" Target="../embeddings/oleObject20.bin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1.vml"/><Relationship Id="rId6" Type="http://schemas.openxmlformats.org/officeDocument/2006/relationships/image" Target="../media/image49.jpeg"/><Relationship Id="rId5" Type="http://schemas.openxmlformats.org/officeDocument/2006/relationships/image" Target="../media/image45.emf"/><Relationship Id="rId4" Type="http://schemas.openxmlformats.org/officeDocument/2006/relationships/oleObject" Target="../embeddings/oleObject21.bin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2.vml"/><Relationship Id="rId6" Type="http://schemas.openxmlformats.org/officeDocument/2006/relationships/image" Target="../media/image49.jpeg"/><Relationship Id="rId5" Type="http://schemas.openxmlformats.org/officeDocument/2006/relationships/image" Target="../media/image45.emf"/><Relationship Id="rId4" Type="http://schemas.openxmlformats.org/officeDocument/2006/relationships/oleObject" Target="../embeddings/oleObject22.bin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3.vml"/><Relationship Id="rId6" Type="http://schemas.openxmlformats.org/officeDocument/2006/relationships/image" Target="../media/image52.jpeg"/><Relationship Id="rId5" Type="http://schemas.openxmlformats.org/officeDocument/2006/relationships/image" Target="../media/image45.emf"/><Relationship Id="rId4" Type="http://schemas.openxmlformats.org/officeDocument/2006/relationships/oleObject" Target="../embeddings/oleObject23.bin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4.vml"/><Relationship Id="rId5" Type="http://schemas.openxmlformats.org/officeDocument/2006/relationships/image" Target="../media/image54.emf"/><Relationship Id="rId4" Type="http://schemas.openxmlformats.org/officeDocument/2006/relationships/image" Target="../media/image53.emf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5.vml"/><Relationship Id="rId6" Type="http://schemas.openxmlformats.org/officeDocument/2006/relationships/image" Target="../media/image57.jpeg"/><Relationship Id="rId5" Type="http://schemas.openxmlformats.org/officeDocument/2006/relationships/image" Target="../media/image55.emf"/><Relationship Id="rId4" Type="http://schemas.openxmlformats.org/officeDocument/2006/relationships/oleObject" Target="../embeddings/oleObject25.bin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6.vml"/><Relationship Id="rId6" Type="http://schemas.openxmlformats.org/officeDocument/2006/relationships/image" Target="../media/image59.jpeg"/><Relationship Id="rId5" Type="http://schemas.openxmlformats.org/officeDocument/2006/relationships/image" Target="../media/image55.emf"/><Relationship Id="rId4" Type="http://schemas.openxmlformats.org/officeDocument/2006/relationships/oleObject" Target="../embeddings/oleObject26.bin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7.vml"/><Relationship Id="rId6" Type="http://schemas.openxmlformats.org/officeDocument/2006/relationships/image" Target="../media/image61.jpeg"/><Relationship Id="rId5" Type="http://schemas.openxmlformats.org/officeDocument/2006/relationships/image" Target="../media/image55.emf"/><Relationship Id="rId4" Type="http://schemas.openxmlformats.org/officeDocument/2006/relationships/oleObject" Target="../embeddings/oleObject27.bin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8.vml"/><Relationship Id="rId5" Type="http://schemas.openxmlformats.org/officeDocument/2006/relationships/image" Target="../media/image62.emf"/><Relationship Id="rId4" Type="http://schemas.openxmlformats.org/officeDocument/2006/relationships/oleObject" Target="../embeddings/oleObject28.bin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9.vml"/><Relationship Id="rId6" Type="http://schemas.openxmlformats.org/officeDocument/2006/relationships/image" Target="../media/image66.jpeg"/><Relationship Id="rId5" Type="http://schemas.openxmlformats.org/officeDocument/2006/relationships/image" Target="../media/image64.emf"/><Relationship Id="rId4" Type="http://schemas.openxmlformats.org/officeDocument/2006/relationships/oleObject" Target="../embeddings/oleObject29.bin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0.vml"/><Relationship Id="rId6" Type="http://schemas.openxmlformats.org/officeDocument/2006/relationships/image" Target="../media/image68.jpeg"/><Relationship Id="rId5" Type="http://schemas.openxmlformats.org/officeDocument/2006/relationships/image" Target="../media/image64.emf"/><Relationship Id="rId4" Type="http://schemas.openxmlformats.org/officeDocument/2006/relationships/oleObject" Target="../embeddings/oleObject30.bin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1.vml"/><Relationship Id="rId6" Type="http://schemas.openxmlformats.org/officeDocument/2006/relationships/image" Target="../media/image71.jpeg"/><Relationship Id="rId5" Type="http://schemas.openxmlformats.org/officeDocument/2006/relationships/image" Target="../media/image69.emf"/><Relationship Id="rId4" Type="http://schemas.openxmlformats.org/officeDocument/2006/relationships/oleObject" Target="../embeddings/oleObject31.bin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2.vml"/><Relationship Id="rId5" Type="http://schemas.openxmlformats.org/officeDocument/2006/relationships/image" Target="../media/image73.emf"/><Relationship Id="rId4" Type="http://schemas.openxmlformats.org/officeDocument/2006/relationships/image" Target="../media/image72.emf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3.vml"/><Relationship Id="rId6" Type="http://schemas.openxmlformats.org/officeDocument/2006/relationships/image" Target="../media/image76.jpeg"/><Relationship Id="rId5" Type="http://schemas.openxmlformats.org/officeDocument/2006/relationships/image" Target="../media/image74.emf"/><Relationship Id="rId4" Type="http://schemas.openxmlformats.org/officeDocument/2006/relationships/oleObject" Target="../embeddings/oleObject33.bin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4.vml"/><Relationship Id="rId6" Type="http://schemas.openxmlformats.org/officeDocument/2006/relationships/image" Target="../media/image78.jpeg"/><Relationship Id="rId5" Type="http://schemas.openxmlformats.org/officeDocument/2006/relationships/image" Target="../media/image74.emf"/><Relationship Id="rId4" Type="http://schemas.openxmlformats.org/officeDocument/2006/relationships/oleObject" Target="../embeddings/oleObject34.bin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5.vml"/><Relationship Id="rId6" Type="http://schemas.openxmlformats.org/officeDocument/2006/relationships/image" Target="../media/image78.jpeg"/><Relationship Id="rId5" Type="http://schemas.openxmlformats.org/officeDocument/2006/relationships/image" Target="../media/image74.emf"/><Relationship Id="rId4" Type="http://schemas.openxmlformats.org/officeDocument/2006/relationships/oleObject" Target="../embeddings/oleObject35.bin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6.vml"/><Relationship Id="rId6" Type="http://schemas.openxmlformats.org/officeDocument/2006/relationships/image" Target="../media/image78.jpeg"/><Relationship Id="rId5" Type="http://schemas.openxmlformats.org/officeDocument/2006/relationships/image" Target="../media/image74.emf"/><Relationship Id="rId4" Type="http://schemas.openxmlformats.org/officeDocument/2006/relationships/oleObject" Target="../embeddings/oleObject36.bin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7.vml"/><Relationship Id="rId6" Type="http://schemas.openxmlformats.org/officeDocument/2006/relationships/image" Target="../media/image82.jpeg"/><Relationship Id="rId5" Type="http://schemas.openxmlformats.org/officeDocument/2006/relationships/image" Target="../media/image74.emf"/><Relationship Id="rId4" Type="http://schemas.openxmlformats.org/officeDocument/2006/relationships/oleObject" Target="../embeddings/oleObject37.bin"/></Relationships>
</file>

<file path=ppt/slides/_rels/slide5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8.vml"/><Relationship Id="rId5" Type="http://schemas.openxmlformats.org/officeDocument/2006/relationships/image" Target="../media/image83.emf"/><Relationship Id="rId4" Type="http://schemas.openxmlformats.org/officeDocument/2006/relationships/oleObject" Target="../embeddings/oleObject38.bin"/></Relationships>
</file>

<file path=ppt/slides/_rels/slide5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9.vml"/><Relationship Id="rId6" Type="http://schemas.openxmlformats.org/officeDocument/2006/relationships/image" Target="../media/image87.jpeg"/><Relationship Id="rId5" Type="http://schemas.openxmlformats.org/officeDocument/2006/relationships/image" Target="../media/image85.emf"/><Relationship Id="rId4" Type="http://schemas.openxmlformats.org/officeDocument/2006/relationships/oleObject" Target="../embeddings/oleObject39.bin"/></Relationships>
</file>

<file path=ppt/slides/_rels/slide5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8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0.vml"/><Relationship Id="rId6" Type="http://schemas.openxmlformats.org/officeDocument/2006/relationships/image" Target="../media/image89.jpeg"/><Relationship Id="rId5" Type="http://schemas.openxmlformats.org/officeDocument/2006/relationships/image" Target="../media/image85.emf"/><Relationship Id="rId4" Type="http://schemas.openxmlformats.org/officeDocument/2006/relationships/oleObject" Target="../embeddings/oleObject40.bin"/></Relationships>
</file>

<file path=ppt/slides/_rels/slide5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1.vml"/><Relationship Id="rId5" Type="http://schemas.openxmlformats.org/officeDocument/2006/relationships/image" Target="../media/image90.emf"/><Relationship Id="rId4" Type="http://schemas.openxmlformats.org/officeDocument/2006/relationships/oleObject" Target="../embeddings/oleObject41.bin"/></Relationships>
</file>

<file path=ppt/slides/_rels/slide5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2.vml"/><Relationship Id="rId6" Type="http://schemas.openxmlformats.org/officeDocument/2006/relationships/image" Target="../media/image94.jpeg"/><Relationship Id="rId5" Type="http://schemas.openxmlformats.org/officeDocument/2006/relationships/image" Target="../media/image92.emf"/><Relationship Id="rId4" Type="http://schemas.openxmlformats.org/officeDocument/2006/relationships/oleObject" Target="../embeddings/oleObject42.bin"/></Relationships>
</file>

<file path=ppt/slides/_rels/slide5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3.vml"/><Relationship Id="rId5" Type="http://schemas.openxmlformats.org/officeDocument/2006/relationships/image" Target="../media/image96.emf"/><Relationship Id="rId4" Type="http://schemas.openxmlformats.org/officeDocument/2006/relationships/image" Target="../media/image9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88307" y="285703"/>
            <a:ext cx="8367386" cy="62865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and Characterization of Simvastatin and its Metabolites in Rat Tissues and Biological Fluids using MALDI High Resolution Mass Spectrometry Approach</a:t>
            </a:r>
          </a:p>
          <a:p>
            <a:pPr algn="just">
              <a:lnSpc>
                <a:spcPct val="200000"/>
              </a:lnSpc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ncui Yin, Reem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wabli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ohamed W.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tw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. F. M. Motiur Rahman,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dnan A.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di</a:t>
            </a:r>
            <a:r>
              <a:rPr lang="en-US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Pharmaceutical Chemistry, College of Pharmacy, King Saud University, Riyadh 11451, KSA</a:t>
            </a:r>
          </a:p>
          <a:p>
            <a:pPr algn="just">
              <a:lnSpc>
                <a:spcPct val="200000"/>
              </a:lnSpc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sponding Authors: Tel: +966114670237; Fax: +966114676220; Email: afmrahman@ksu.edu.sa (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F. M.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tiur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ahman); akadi@ksu.edu.sa (Adnan A </a:t>
            </a:r>
            <a:r>
              <a:rPr lang="en-GB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di</a:t>
            </a:r>
            <a:r>
              <a:rPr lang="en-GB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32476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5572909"/>
              </p:ext>
            </p:extLst>
          </p:nvPr>
        </p:nvGraphicFramePr>
        <p:xfrm>
          <a:off x="409705" y="1135927"/>
          <a:ext cx="8388090" cy="505227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61822">
                  <a:extLst>
                    <a:ext uri="{9D8B030D-6E8A-4147-A177-3AD203B41FA5}">
                      <a16:colId xmlns:a16="http://schemas.microsoft.com/office/drawing/2014/main" val="3891350189"/>
                    </a:ext>
                  </a:extLst>
                </a:gridCol>
                <a:gridCol w="2129424">
                  <a:extLst>
                    <a:ext uri="{9D8B030D-6E8A-4147-A177-3AD203B41FA5}">
                      <a16:colId xmlns:a16="http://schemas.microsoft.com/office/drawing/2014/main" val="929642525"/>
                    </a:ext>
                  </a:extLst>
                </a:gridCol>
                <a:gridCol w="1903956">
                  <a:extLst>
                    <a:ext uri="{9D8B030D-6E8A-4147-A177-3AD203B41FA5}">
                      <a16:colId xmlns:a16="http://schemas.microsoft.com/office/drawing/2014/main" val="1426119296"/>
                    </a:ext>
                  </a:extLst>
                </a:gridCol>
                <a:gridCol w="2592888">
                  <a:extLst>
                    <a:ext uri="{9D8B030D-6E8A-4147-A177-3AD203B41FA5}">
                      <a16:colId xmlns:a16="http://schemas.microsoft.com/office/drawing/2014/main" val="374368769"/>
                    </a:ext>
                  </a:extLst>
                </a:gridCol>
              </a:tblGrid>
              <a:tr h="619693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Biological Samples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Detected Metabolites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LC-MS (Ion trap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MALDI-LTQ-</a:t>
                      </a:r>
                      <a:r>
                        <a:rPr lang="en-US" sz="1600" dirty="0" err="1">
                          <a:effectLst/>
                        </a:rPr>
                        <a:t>Orbitrap</a:t>
                      </a:r>
                      <a:r>
                        <a:rPr lang="en-US" sz="1600" dirty="0">
                          <a:effectLst/>
                        </a:rPr>
                        <a:t>-MS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extLst>
                  <a:ext uri="{0D108BD9-81ED-4DB2-BD59-A6C34878D82A}">
                    <a16:rowId xmlns:a16="http://schemas.microsoft.com/office/drawing/2014/main" val="2745030573"/>
                  </a:ext>
                </a:extLst>
              </a:tr>
              <a:tr h="233294">
                <a:tc rowSpan="9"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Feces</a:t>
                      </a:r>
                      <a:endParaRPr lang="en-US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699790715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Monohydroxy</a:t>
                      </a:r>
                      <a:r>
                        <a:rPr lang="en-US" sz="1400" dirty="0">
                          <a:effectLst/>
                        </a:rPr>
                        <a:t>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085946348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Reduced 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071012630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Exomethylene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884403501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Carboxyl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083141463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Dihydroxy</a:t>
                      </a:r>
                      <a:r>
                        <a:rPr lang="en-US" sz="1400" dirty="0">
                          <a:effectLst/>
                        </a:rPr>
                        <a:t>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047640121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ihydrodiol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831611575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V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928809723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</a:t>
                      </a:r>
                      <a:r>
                        <a:rPr lang="en-US" sz="1400" dirty="0">
                          <a:effectLst/>
                        </a:rPr>
                        <a:t>-</a:t>
                      </a:r>
                      <a:r>
                        <a:rPr lang="en-US" sz="1400" dirty="0" err="1">
                          <a:effectLst/>
                        </a:rPr>
                        <a:t>oxidated</a:t>
                      </a:r>
                      <a:r>
                        <a:rPr lang="en-US" sz="1400" dirty="0">
                          <a:effectLst/>
                        </a:rPr>
                        <a:t> SV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695661557"/>
                  </a:ext>
                </a:extLst>
              </a:tr>
              <a:tr h="233294">
                <a:tc rowSpan="10"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Urine</a:t>
                      </a:r>
                      <a:endParaRPr lang="en-US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  <a:p>
                      <a:pPr marL="0" marR="0" indent="18034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 </a:t>
                      </a:r>
                      <a:endParaRPr lang="en-US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13408227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Reduced 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707643869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Dihydroxy</a:t>
                      </a:r>
                      <a:r>
                        <a:rPr lang="en-US" sz="1400" dirty="0">
                          <a:effectLst/>
                        </a:rPr>
                        <a:t>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605461339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Exomethylene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086229099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Monohydroxy</a:t>
                      </a:r>
                      <a:r>
                        <a:rPr lang="en-US" sz="1400" dirty="0">
                          <a:effectLst/>
                        </a:rPr>
                        <a:t>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864505806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Carboxyl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907207385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ihydrodiol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005776958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DMHB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898965188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Glu</a:t>
                      </a:r>
                      <a:r>
                        <a:rPr lang="en-US" sz="1400" dirty="0">
                          <a:effectLst/>
                        </a:rPr>
                        <a:t>-DMB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315474396"/>
                  </a:ext>
                </a:extLst>
              </a:tr>
              <a:tr h="233294">
                <a:tc vMerge="1">
                  <a:txBody>
                    <a:bodyPr/>
                    <a:lstStyle/>
                    <a:p>
                      <a:pPr marL="0" marR="0" indent="18034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Gly</a:t>
                      </a:r>
                      <a:r>
                        <a:rPr lang="en-US" sz="1400" dirty="0">
                          <a:effectLst/>
                        </a:rPr>
                        <a:t>-DMB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884533236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258382" y="246365"/>
            <a:ext cx="85725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Table S-6</a:t>
            </a:r>
            <a:r>
              <a:rPr 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. Comparison of Metabolites detected in LC-MS and MALDI-</a:t>
            </a:r>
            <a:r>
              <a:rPr lang="en-US" kern="1600" dirty="0" err="1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Orbitrap</a:t>
            </a:r>
            <a:r>
              <a:rPr 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-MS (Combined metabolite profile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7785100" y="6426200"/>
            <a:ext cx="1206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inue ..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91059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9469117"/>
              </p:ext>
            </p:extLst>
          </p:nvPr>
        </p:nvGraphicFramePr>
        <p:xfrm>
          <a:off x="317500" y="1278341"/>
          <a:ext cx="8438193" cy="500395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60599">
                  <a:extLst>
                    <a:ext uri="{9D8B030D-6E8A-4147-A177-3AD203B41FA5}">
                      <a16:colId xmlns:a16="http://schemas.microsoft.com/office/drawing/2014/main" val="3891350189"/>
                    </a:ext>
                  </a:extLst>
                </a:gridCol>
                <a:gridCol w="2234772">
                  <a:extLst>
                    <a:ext uri="{9D8B030D-6E8A-4147-A177-3AD203B41FA5}">
                      <a16:colId xmlns:a16="http://schemas.microsoft.com/office/drawing/2014/main" val="929642525"/>
                    </a:ext>
                  </a:extLst>
                </a:gridCol>
                <a:gridCol w="1887930">
                  <a:extLst>
                    <a:ext uri="{9D8B030D-6E8A-4147-A177-3AD203B41FA5}">
                      <a16:colId xmlns:a16="http://schemas.microsoft.com/office/drawing/2014/main" val="1426119296"/>
                    </a:ext>
                  </a:extLst>
                </a:gridCol>
                <a:gridCol w="2354892">
                  <a:extLst>
                    <a:ext uri="{9D8B030D-6E8A-4147-A177-3AD203B41FA5}">
                      <a16:colId xmlns:a16="http://schemas.microsoft.com/office/drawing/2014/main" val="374368769"/>
                    </a:ext>
                  </a:extLst>
                </a:gridCol>
              </a:tblGrid>
              <a:tr h="736754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Biological Samples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Detected Metabolites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LC-MS (Ion trap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MALDI-LTQ-</a:t>
                      </a:r>
                      <a:r>
                        <a:rPr lang="en-US" sz="1600" dirty="0" err="1">
                          <a:effectLst/>
                        </a:rPr>
                        <a:t>Orbitrap</a:t>
                      </a:r>
                      <a:r>
                        <a:rPr lang="en-US" sz="1600" dirty="0">
                          <a:effectLst/>
                        </a:rPr>
                        <a:t>-MS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extLst>
                  <a:ext uri="{0D108BD9-81ED-4DB2-BD59-A6C34878D82A}">
                    <a16:rowId xmlns:a16="http://schemas.microsoft.com/office/drawing/2014/main" val="2745030573"/>
                  </a:ext>
                </a:extLst>
              </a:tr>
              <a:tr h="173548">
                <a:tc rowSpan="10"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Serum</a:t>
                      </a:r>
                      <a:endParaRPr lang="en-US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314156654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Reduced 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835967771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Exomethylene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9839553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Carboxyl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872051732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err="1">
                          <a:effectLst/>
                        </a:rPr>
                        <a:t>Monohydroxy</a:t>
                      </a:r>
                      <a:r>
                        <a:rPr lang="en-US" sz="1400" b="0" dirty="0">
                          <a:effectLst/>
                        </a:rPr>
                        <a:t>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962265625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err="1">
                          <a:effectLst/>
                        </a:rPr>
                        <a:t>Dihydroxy</a:t>
                      </a:r>
                      <a:r>
                        <a:rPr lang="en-US" sz="1400" b="0" dirty="0">
                          <a:effectLst/>
                        </a:rPr>
                        <a:t>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237089619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Dihydrodiol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447056265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DMB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658863921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DMHB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165601411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SVA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115249449"/>
                  </a:ext>
                </a:extLst>
              </a:tr>
              <a:tr h="173548">
                <a:tc rowSpan="10"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</a:rPr>
                        <a:t>Lung</a:t>
                      </a:r>
                      <a:endParaRPr lang="en-US" sz="20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53494668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err="1">
                          <a:effectLst/>
                        </a:rPr>
                        <a:t>Monohydroxy</a:t>
                      </a:r>
                      <a:r>
                        <a:rPr lang="en-US" sz="1400" b="0" dirty="0">
                          <a:effectLst/>
                        </a:rPr>
                        <a:t>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912567524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Exomethylene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601798050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Reduced 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17184174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Carboxyl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639724971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 err="1">
                          <a:effectLst/>
                        </a:rPr>
                        <a:t>Dihydroxy</a:t>
                      </a:r>
                      <a:r>
                        <a:rPr lang="en-US" sz="1400" b="0" dirty="0">
                          <a:effectLst/>
                        </a:rPr>
                        <a:t>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136752853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Dihydrodiol-SV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621512702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DMB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316392481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DMHB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447252377"/>
                  </a:ext>
                </a:extLst>
              </a:tr>
              <a:tr h="173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effectLst/>
                        </a:rPr>
                        <a:t>SVA</a:t>
                      </a:r>
                      <a:endParaRPr lang="en-US" sz="1400" b="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195566904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785100" y="6426200"/>
            <a:ext cx="1206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inue ..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1</a:t>
            </a:fld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B1080C6-1BC7-48AA-ACEE-E72CA94524D3}"/>
              </a:ext>
            </a:extLst>
          </p:cNvPr>
          <p:cNvSpPr/>
          <p:nvPr/>
        </p:nvSpPr>
        <p:spPr>
          <a:xfrm>
            <a:off x="258382" y="246365"/>
            <a:ext cx="85725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Table S-6</a:t>
            </a:r>
            <a:r>
              <a:rPr 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. Comparison of Metabolites detected in LC-MS and MALDI-</a:t>
            </a:r>
            <a:r>
              <a:rPr lang="en-US" kern="1600" dirty="0" err="1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Orbitrap</a:t>
            </a:r>
            <a:r>
              <a:rPr 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-MS (Combined metabolite profile)</a:t>
            </a:r>
          </a:p>
        </p:txBody>
      </p:sp>
    </p:spTree>
    <p:extLst>
      <p:ext uri="{BB962C8B-B14F-4D97-AF65-F5344CB8AC3E}">
        <p14:creationId xmlns:p14="http://schemas.microsoft.com/office/powerpoint/2010/main" val="142784588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6663426"/>
              </p:ext>
            </p:extLst>
          </p:nvPr>
        </p:nvGraphicFramePr>
        <p:xfrm>
          <a:off x="335854" y="1840457"/>
          <a:ext cx="8179496" cy="404438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954061">
                  <a:extLst>
                    <a:ext uri="{9D8B030D-6E8A-4147-A177-3AD203B41FA5}">
                      <a16:colId xmlns:a16="http://schemas.microsoft.com/office/drawing/2014/main" val="3891350189"/>
                    </a:ext>
                  </a:extLst>
                </a:gridCol>
                <a:gridCol w="2054269">
                  <a:extLst>
                    <a:ext uri="{9D8B030D-6E8A-4147-A177-3AD203B41FA5}">
                      <a16:colId xmlns:a16="http://schemas.microsoft.com/office/drawing/2014/main" val="929642525"/>
                    </a:ext>
                  </a:extLst>
                </a:gridCol>
                <a:gridCol w="1929008">
                  <a:extLst>
                    <a:ext uri="{9D8B030D-6E8A-4147-A177-3AD203B41FA5}">
                      <a16:colId xmlns:a16="http://schemas.microsoft.com/office/drawing/2014/main" val="1426119296"/>
                    </a:ext>
                  </a:extLst>
                </a:gridCol>
                <a:gridCol w="2242158">
                  <a:extLst>
                    <a:ext uri="{9D8B030D-6E8A-4147-A177-3AD203B41FA5}">
                      <a16:colId xmlns:a16="http://schemas.microsoft.com/office/drawing/2014/main" val="374368769"/>
                    </a:ext>
                  </a:extLst>
                </a:gridCol>
              </a:tblGrid>
              <a:tr h="417263">
                <a:tc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ological Samples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etected Metabolites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C-MS (Ion trap)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LDI-LTQ-</a:t>
                      </a:r>
                      <a:r>
                        <a:rPr lang="en-US" sz="1600" b="1" kern="1200" dirty="0" err="1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rbitrap</a:t>
                      </a: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MS</a:t>
                      </a:r>
                    </a:p>
                  </a:txBody>
                  <a:tcPr marL="12177" marR="12177" marT="0" marB="0" anchor="ctr"/>
                </a:tc>
                <a:extLst>
                  <a:ext uri="{0D108BD9-81ED-4DB2-BD59-A6C34878D82A}">
                    <a16:rowId xmlns:a16="http://schemas.microsoft.com/office/drawing/2014/main" val="2745030573"/>
                  </a:ext>
                </a:extLst>
              </a:tr>
              <a:tr h="184632">
                <a:tc rowSpan="7"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iver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849353817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Reduced 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850884449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Exomethylene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066452562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Carboxyl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218431414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</a:rPr>
                        <a:t>Monohydroxy</a:t>
                      </a:r>
                      <a:r>
                        <a:rPr lang="en-US" sz="1400" dirty="0">
                          <a:effectLst/>
                        </a:rPr>
                        <a:t>-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087499441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</a:t>
                      </a:r>
                      <a:r>
                        <a:rPr lang="en-US" sz="1400">
                          <a:effectLst/>
                        </a:rPr>
                        <a:t>-oxidated SVA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880749441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VA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50892229"/>
                  </a:ext>
                </a:extLst>
              </a:tr>
              <a:tr h="184632">
                <a:tc rowSpan="10"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eart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51893074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Reduced 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638125780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xomethylene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998836912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Carboxyl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218078989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nohydroxy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617983876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ihydroxy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88578749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ihydrodiol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723315339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MB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826922834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MHB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239668542"/>
                  </a:ext>
                </a:extLst>
              </a:tr>
              <a:tr h="18463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SVA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037331956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785100" y="6426200"/>
            <a:ext cx="1206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inue ..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2</a:t>
            </a:fld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B012B87D-22F2-446C-BFD4-3EAE2ECFB57A}"/>
              </a:ext>
            </a:extLst>
          </p:cNvPr>
          <p:cNvSpPr/>
          <p:nvPr/>
        </p:nvSpPr>
        <p:spPr>
          <a:xfrm>
            <a:off x="258382" y="246365"/>
            <a:ext cx="85725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Table S-6</a:t>
            </a:r>
            <a:r>
              <a:rPr 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. Comparison of Metabolites detected in LC-MS and MALDI-</a:t>
            </a:r>
            <a:r>
              <a:rPr lang="en-US" kern="1600" dirty="0" err="1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Orbitrap</a:t>
            </a:r>
            <a:r>
              <a:rPr 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-MS (Combined metabolite profile)</a:t>
            </a:r>
          </a:p>
        </p:txBody>
      </p:sp>
    </p:spTree>
    <p:extLst>
      <p:ext uri="{BB962C8B-B14F-4D97-AF65-F5344CB8AC3E}">
        <p14:creationId xmlns:p14="http://schemas.microsoft.com/office/powerpoint/2010/main" val="105692140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5603287"/>
              </p:ext>
            </p:extLst>
          </p:nvPr>
        </p:nvGraphicFramePr>
        <p:xfrm>
          <a:off x="317500" y="1570048"/>
          <a:ext cx="8197850" cy="423265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799399">
                  <a:extLst>
                    <a:ext uri="{9D8B030D-6E8A-4147-A177-3AD203B41FA5}">
                      <a16:colId xmlns:a16="http://schemas.microsoft.com/office/drawing/2014/main" val="3891350189"/>
                    </a:ext>
                  </a:extLst>
                </a:gridCol>
                <a:gridCol w="2204580">
                  <a:extLst>
                    <a:ext uri="{9D8B030D-6E8A-4147-A177-3AD203B41FA5}">
                      <a16:colId xmlns:a16="http://schemas.microsoft.com/office/drawing/2014/main" val="929642525"/>
                    </a:ext>
                  </a:extLst>
                </a:gridCol>
                <a:gridCol w="2041743">
                  <a:extLst>
                    <a:ext uri="{9D8B030D-6E8A-4147-A177-3AD203B41FA5}">
                      <a16:colId xmlns:a16="http://schemas.microsoft.com/office/drawing/2014/main" val="1426119296"/>
                    </a:ext>
                  </a:extLst>
                </a:gridCol>
                <a:gridCol w="2152128">
                  <a:extLst>
                    <a:ext uri="{9D8B030D-6E8A-4147-A177-3AD203B41FA5}">
                      <a16:colId xmlns:a16="http://schemas.microsoft.com/office/drawing/2014/main" val="374368769"/>
                    </a:ext>
                  </a:extLst>
                </a:gridCol>
              </a:tblGrid>
              <a:tr h="546850">
                <a:tc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iological Samples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Detected Metabolites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C-MS (Ion trap)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ALDI-LTQ-</a:t>
                      </a:r>
                      <a:r>
                        <a:rPr lang="en-US" sz="1600" b="1" kern="1200" dirty="0" err="1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Orbitrap</a:t>
                      </a:r>
                      <a:r>
                        <a:rPr lang="en-US" sz="16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-MS</a:t>
                      </a:r>
                    </a:p>
                  </a:txBody>
                  <a:tcPr marL="12177" marR="12177" marT="0" marB="0" anchor="ctr"/>
                </a:tc>
                <a:extLst>
                  <a:ext uri="{0D108BD9-81ED-4DB2-BD59-A6C34878D82A}">
                    <a16:rowId xmlns:a16="http://schemas.microsoft.com/office/drawing/2014/main" val="2745030573"/>
                  </a:ext>
                </a:extLst>
              </a:tr>
              <a:tr h="409534">
                <a:tc rowSpan="9">
                  <a:txBody>
                    <a:bodyPr/>
                    <a:lstStyle/>
                    <a:p>
                      <a:pPr marL="0" marR="0" indent="0" algn="ctr" defTabSz="914400" rtl="0" eaLnBrk="1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Kidney</a:t>
                      </a:r>
                    </a:p>
                  </a:txBody>
                  <a:tcPr marL="12177" marR="12177" marT="0" marB="0" anchor="ctr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Reduced SV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104452"/>
                  </a:ext>
                </a:extLst>
              </a:tr>
              <a:tr h="4095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Monohydroxy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12402723"/>
                  </a:ext>
                </a:extLst>
              </a:tr>
              <a:tr h="4095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ihydrodiol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975587100"/>
                  </a:ext>
                </a:extLst>
              </a:tr>
              <a:tr h="4095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Exomethylene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457638105"/>
                  </a:ext>
                </a:extLst>
              </a:tr>
              <a:tr h="4095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ihydroxy-SV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694447520"/>
                  </a:ext>
                </a:extLst>
              </a:tr>
              <a:tr h="4095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DMHB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248485553"/>
                  </a:ext>
                </a:extLst>
              </a:tr>
              <a:tr h="4095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lu-DMB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1791960766"/>
                  </a:ext>
                </a:extLst>
              </a:tr>
              <a:tr h="4095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ly-DMB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2190004294"/>
                  </a:ext>
                </a:extLst>
              </a:tr>
              <a:tr h="40953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SVA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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tc>
                  <a:txBody>
                    <a:bodyPr/>
                    <a:lstStyle/>
                    <a:p>
                      <a:pPr marL="0" marR="0" indent="18034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sym typeface="Symbol" panose="05050102010706020507" pitchFamily="18" charset="2"/>
                        </a:rPr>
                        <a:t>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12177" marR="12177" marT="0" marB="0"/>
                </a:tc>
                <a:extLst>
                  <a:ext uri="{0D108BD9-81ED-4DB2-BD59-A6C34878D82A}">
                    <a16:rowId xmlns:a16="http://schemas.microsoft.com/office/drawing/2014/main" val="3109196648"/>
                  </a:ext>
                </a:extLst>
              </a:tr>
            </a:tbl>
          </a:graphicData>
        </a:graphic>
      </p:graphicFrame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3</a:t>
            </a:fld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BE17B86C-36E9-423A-9B31-8737A6E0ACAA}"/>
              </a:ext>
            </a:extLst>
          </p:cNvPr>
          <p:cNvSpPr/>
          <p:nvPr/>
        </p:nvSpPr>
        <p:spPr>
          <a:xfrm>
            <a:off x="258382" y="246365"/>
            <a:ext cx="85725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Table S-6</a:t>
            </a:r>
            <a:r>
              <a:rPr 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. Comparison of Metabolites detected in LC-MS and MALDI-</a:t>
            </a:r>
            <a:r>
              <a:rPr lang="en-US" kern="1600" dirty="0" err="1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Orbitrap</a:t>
            </a:r>
            <a:r>
              <a:rPr 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-MS (Combined metabolite profile)</a:t>
            </a:r>
          </a:p>
        </p:txBody>
      </p:sp>
    </p:spTree>
    <p:extLst>
      <p:ext uri="{BB962C8B-B14F-4D97-AF65-F5344CB8AC3E}">
        <p14:creationId xmlns:p14="http://schemas.microsoft.com/office/powerpoint/2010/main" val="348742218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72471" y="317500"/>
            <a:ext cx="850669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um of SV/M1 obtained in orbitrap mass spectrometer (SV, also a possible metabolite through reversible reaction from SVA, was observed in positive mode with accurate mass a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419.27902 [M+H]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exact mass: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419.27920 [M+H]</a:t>
            </a:r>
            <a:r>
              <a:rPr lang="en-US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with mass accuracy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0.4 ppm.)</a:t>
            </a:r>
          </a:p>
        </p:txBody>
      </p:sp>
      <p:pic>
        <p:nvPicPr>
          <p:cNvPr id="3" name="Picture 2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93790" y="1754326"/>
            <a:ext cx="7543628" cy="44342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Rectangle 3"/>
          <p:cNvSpPr/>
          <p:nvPr/>
        </p:nvSpPr>
        <p:spPr>
          <a:xfrm>
            <a:off x="628650" y="6075376"/>
            <a:ext cx="7621560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</a:pP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. Mass spectrum of </a:t>
            </a:r>
            <a:r>
              <a:rPr lang="en-US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V/M1 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btained in orbitrap mass spectrometer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4</a:t>
            </a:fld>
            <a:endParaRPr lang="en-US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41289848"/>
              </p:ext>
            </p:extLst>
          </p:nvPr>
        </p:nvGraphicFramePr>
        <p:xfrm>
          <a:off x="5745007" y="3023690"/>
          <a:ext cx="1516063" cy="1663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82" name="CS ChemDraw Drawing" r:id="rId4" imgW="1515988" imgH="1663871" progId="ChemDraw.Document.6.0">
                  <p:embed/>
                </p:oleObj>
              </mc:Choice>
              <mc:Fallback>
                <p:oleObj name="CS ChemDraw Drawing" r:id="rId4" imgW="1515988" imgH="1663871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45007" y="3023690"/>
                        <a:ext cx="1516063" cy="1663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6452032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50717" y="255722"/>
            <a:ext cx="826077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other possible hydroxylation product dihydroxy SV was observed in positive mode with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1.26903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1.26825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with mass accuracy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.7 ppm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50717" y="1424796"/>
            <a:ext cx="7574974" cy="45395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2322092"/>
              </p:ext>
            </p:extLst>
          </p:nvPr>
        </p:nvGraphicFramePr>
        <p:xfrm>
          <a:off x="2020599" y="3173990"/>
          <a:ext cx="1628775" cy="1495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95" name="CS ChemDraw Drawing" r:id="rId4" imgW="1636200" imgH="1505160" progId="ChemDraw.Document.6.0">
                  <p:embed/>
                </p:oleObj>
              </mc:Choice>
              <mc:Fallback>
                <p:oleObj name="CS ChemDraw Drawing" r:id="rId4" imgW="1636200" imgH="150516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20599" y="3173990"/>
                        <a:ext cx="1628775" cy="14954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540326" y="6025460"/>
            <a:ext cx="860367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Figure S-2. Mass spectrum of Dihydroxy-SV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3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obtained in orbitrap mass spectrometer.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08324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8208" y="322118"/>
            <a:ext cx="827116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possible dihydroxylation along with reductive product dihydrodiol SV was observed in positive mode with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3.28452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3.28468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with mass accuracy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-0.4 ppm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47155" y="1434868"/>
            <a:ext cx="7813618" cy="4529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4" name="Group 3"/>
          <p:cNvGrpSpPr/>
          <p:nvPr/>
        </p:nvGrpSpPr>
        <p:grpSpPr>
          <a:xfrm>
            <a:off x="2232774" y="3150927"/>
            <a:ext cx="1593215" cy="756286"/>
            <a:chOff x="197715" y="222428"/>
            <a:chExt cx="1593407" cy="756579"/>
          </a:xfrm>
        </p:grpSpPr>
        <p:sp>
          <p:nvSpPr>
            <p:cNvPr id="5" name="TextBox 5"/>
            <p:cNvSpPr txBox="1"/>
            <p:nvPr/>
          </p:nvSpPr>
          <p:spPr>
            <a:xfrm>
              <a:off x="197715" y="222428"/>
              <a:ext cx="1417955" cy="64960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453.28452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</a:t>
              </a:r>
              <a:r>
                <a:rPr lang="en-US" sz="1050" kern="1200" baseline="-250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25</a:t>
              </a:r>
              <a:r>
                <a:rPr lang="en-US" sz="12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H</a:t>
              </a:r>
              <a:r>
                <a:rPr lang="en-US" sz="1050" kern="1200" baseline="-250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41</a:t>
              </a:r>
              <a:r>
                <a:rPr lang="en-US" sz="12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O</a:t>
              </a:r>
              <a:r>
                <a:rPr lang="en-US" sz="1050" kern="1200" baseline="-250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7</a:t>
              </a:r>
              <a:r>
                <a:rPr lang="en-US" sz="12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=453.28468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-0.36324ppm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6" name="Straight Arrow Connector 5"/>
            <p:cNvCxnSpPr/>
            <p:nvPr/>
          </p:nvCxnSpPr>
          <p:spPr>
            <a:xfrm>
              <a:off x="1429382" y="786441"/>
              <a:ext cx="361740" cy="19256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6831610"/>
              </p:ext>
            </p:extLst>
          </p:nvPr>
        </p:nvGraphicFramePr>
        <p:xfrm>
          <a:off x="4582390" y="2599303"/>
          <a:ext cx="2009775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619" name="CS ChemDraw Drawing" r:id="rId4" imgW="2021040" imgH="1761840" progId="ChemDraw.Document.6.0">
                  <p:embed/>
                </p:oleObj>
              </mc:Choice>
              <mc:Fallback>
                <p:oleObj name="CS ChemDraw Drawing" r:id="rId4" imgW="2021040" imgH="176184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82390" y="2599303"/>
                        <a:ext cx="2009775" cy="17526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Rectangle 7"/>
          <p:cNvSpPr/>
          <p:nvPr/>
        </p:nvSpPr>
        <p:spPr>
          <a:xfrm>
            <a:off x="249381" y="5895468"/>
            <a:ext cx="864523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Figure S-3. Mass spectrum of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Didydrodio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SV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4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obtained in orbitrap mass spectrometer</a:t>
            </a:r>
            <a:endParaRPr lang="en-US" dirty="0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85122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88373" y="245055"/>
            <a:ext cx="808412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Reduced SV, a possible metabolite through reduction reaction of SV, was observed in positive mode with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=421.29367 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=421.29485 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and with mass accuracy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2.8 ppm.</a:t>
            </a:r>
            <a:endParaRPr lang="en-US" dirty="0"/>
          </a:p>
        </p:txBody>
      </p:sp>
      <p:pic>
        <p:nvPicPr>
          <p:cNvPr id="3" name="Picture 2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88372" y="1435186"/>
            <a:ext cx="7969827" cy="47993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1557560"/>
              </p:ext>
            </p:extLst>
          </p:nvPr>
        </p:nvGraphicFramePr>
        <p:xfrm>
          <a:off x="1752023" y="3144405"/>
          <a:ext cx="1673225" cy="1616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573" name="CS ChemDraw Drawing" r:id="rId4" imgW="1861560" imgH="1806120" progId="ChemDraw.Document.6.0">
                  <p:embed/>
                </p:oleObj>
              </mc:Choice>
              <mc:Fallback>
                <p:oleObj name="CS ChemDraw Drawing" r:id="rId4" imgW="1861560" imgH="180612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52023" y="3144405"/>
                        <a:ext cx="1673225" cy="16160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488372" y="6100367"/>
            <a:ext cx="846312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Figure S-4. Mass spectrum of Reduced-SV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5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obtained in orbitrap mass spectrometer.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935079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33846" y="401194"/>
            <a:ext cx="78867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possible oxidative metabolite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ometheylen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was observed in positive mode with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17.26349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17.26355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with mass accuracy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0.1 ppm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106632" y="1497531"/>
            <a:ext cx="6941127" cy="46123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5660806"/>
              </p:ext>
            </p:extLst>
          </p:nvPr>
        </p:nvGraphicFramePr>
        <p:xfrm>
          <a:off x="5115502" y="2768745"/>
          <a:ext cx="1839913" cy="1676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642" name="CS ChemDraw Drawing" r:id="rId4" imgW="1866240" imgH="1706040" progId="ChemDraw.Document.6.0">
                  <p:embed/>
                </p:oleObj>
              </mc:Choice>
              <mc:Fallback>
                <p:oleObj name="CS ChemDraw Drawing" r:id="rId4" imgW="1866240" imgH="170604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15502" y="2768745"/>
                        <a:ext cx="1839913" cy="16764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543502" y="6089072"/>
            <a:ext cx="79770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Figure S-5. Mass spectrum of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Exometheylen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SV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6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obtained in orbitrap mass spectrometer (Single bond to double bond).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05134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93518" y="117361"/>
            <a:ext cx="872836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re are four possible oxidation sites of the given structure indicated below, methyl groups are possibly oxidized to carboxylic acid group, therefore obtained mass is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 449.25338 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 i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 449.25348 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ith mass accuracy of 0.2 ppm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8872" y="1782734"/>
            <a:ext cx="8114637" cy="44622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6776544"/>
              </p:ext>
            </p:extLst>
          </p:nvPr>
        </p:nvGraphicFramePr>
        <p:xfrm>
          <a:off x="4841732" y="3527502"/>
          <a:ext cx="2619375" cy="1647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526" name="CS ChemDraw Drawing" r:id="rId4" imgW="2367720" imgH="1496160" progId="ChemDraw.Document.6.0">
                  <p:embed/>
                </p:oleObj>
              </mc:Choice>
              <mc:Fallback>
                <p:oleObj name="CS ChemDraw Drawing" r:id="rId4" imgW="2367720" imgH="149616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841732" y="3527502"/>
                        <a:ext cx="2619375" cy="16478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/>
          <p:nvPr/>
        </p:nvSpPr>
        <p:spPr>
          <a:xfrm>
            <a:off x="277820" y="6115978"/>
            <a:ext cx="854406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6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. Mass spectrum of carboxyl-SV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7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obtained in orbitrap mass spectrometer.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4593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6588098"/>
              </p:ext>
            </p:extLst>
          </p:nvPr>
        </p:nvGraphicFramePr>
        <p:xfrm>
          <a:off x="470014" y="732077"/>
          <a:ext cx="8045336" cy="54985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0612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23235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068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Entry</a:t>
                      </a:r>
                      <a:r>
                        <a:rPr lang="en-US" baseline="0" dirty="0"/>
                        <a:t> </a:t>
                      </a:r>
                      <a:endParaRPr lang="en-US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ntent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542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S-1 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mount of SV dosing for Group I</a:t>
                      </a:r>
                      <a:endParaRPr kumimoji="0" lang="en-US" altLang="en-US" sz="14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0" lang="en-US" sz="1400" b="0" i="0" u="none" strike="noStrike" kern="1200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S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me of dosing, sacrificing and weight of rat models for Group I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S-3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mount of SV dosing for Group II</a:t>
                      </a:r>
                      <a:endParaRPr kumimoji="0" lang="en-US" altLang="en-US" sz="14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S-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me of dosing, sacrificing and weight of rat models for Group II</a:t>
                      </a:r>
                      <a:endParaRPr kumimoji="0" lang="en-US" altLang="en-US" sz="14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S-5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etabolites from selected pulverized organs in positive/negative mode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able S-6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kern="1600" dirty="0">
                          <a:latin typeface="Times New Roman" panose="02020603050405020304" pitchFamily="18" charset="0"/>
                          <a:ea typeface="ヒラギノ角ゴ Pro W3"/>
                          <a:cs typeface="Times New Roman" panose="02020603050405020304" pitchFamily="18" charset="0"/>
                        </a:rPr>
                        <a:t>Comparison of Metabolites detected in LC-MS and MALDI-</a:t>
                      </a:r>
                      <a:r>
                        <a:rPr lang="en-US" sz="1400" kern="1600" dirty="0" err="1">
                          <a:latin typeface="Times New Roman" panose="02020603050405020304" pitchFamily="18" charset="0"/>
                          <a:ea typeface="ヒラギノ角ゴ Pro W3"/>
                          <a:cs typeface="Times New Roman" panose="02020603050405020304" pitchFamily="18" charset="0"/>
                        </a:rPr>
                        <a:t>Orbitrap</a:t>
                      </a:r>
                      <a:r>
                        <a:rPr lang="en-US" sz="1400" kern="1600" dirty="0">
                          <a:latin typeface="Times New Roman" panose="02020603050405020304" pitchFamily="18" charset="0"/>
                          <a:ea typeface="ヒラギノ角ゴ Pro W3"/>
                          <a:cs typeface="Times New Roman" panose="02020603050405020304" pitchFamily="18" charset="0"/>
                        </a:rPr>
                        <a:t>-MS </a:t>
                      </a:r>
                      <a:endParaRPr lang="en-US" sz="1400" b="1" dirty="0">
                        <a:solidFill>
                          <a:srgbClr val="00B050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-1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60551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ss spectrum of </a:t>
                      </a:r>
                      <a:r>
                        <a:rPr lang="en-US" sz="14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/M1 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btained in orbitrap mass spectrometer</a:t>
                      </a:r>
                      <a:endParaRPr lang="en-US" sz="1400" dirty="0">
                        <a:solidFill>
                          <a:srgbClr val="00B050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ass spectrum of Dihydroxy-SV 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3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obtained in orbitrap mass spectrometer</a:t>
                      </a:r>
                      <a:endParaRPr lang="en-US" sz="1400" kern="1200" noProof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kumimoji="0" lang="en-US" sz="1400" b="0" i="0" u="none" strike="noStrike" kern="1200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ass spectrum of </a:t>
                      </a:r>
                      <a:r>
                        <a:rPr lang="en-US" sz="1400" dirty="0" err="1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Didydrodiol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SV 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4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obtained in orbitrap mass spectrometer</a:t>
                      </a:r>
                      <a:endParaRPr lang="en-US" sz="1400" dirty="0">
                        <a:solidFill>
                          <a:srgbClr val="00B050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ass spectrum of Reduced-SV 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5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obtained in orbitrap mass spectrometer</a:t>
                      </a:r>
                      <a:endParaRPr lang="en-US" sz="1400" b="1" dirty="0">
                        <a:solidFill>
                          <a:srgbClr val="00B050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ass spectrum of </a:t>
                      </a:r>
                      <a:r>
                        <a:rPr lang="en-US" sz="1400" dirty="0" err="1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Exometheylene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SV 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6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obtained in orbitrap mass spectrometer</a:t>
                      </a:r>
                      <a:endParaRPr lang="en-US" sz="14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6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ass spectrum of carboxyl-SV 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7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obtained in orbitrap mass spectrometer</a:t>
                      </a:r>
                      <a:endParaRPr lang="en-US" sz="1400" dirty="0">
                        <a:solidFill>
                          <a:srgbClr val="00B050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ass spectrum of SV-OH 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2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obtained in orbitrap mass spectrometer</a:t>
                      </a:r>
                      <a:endParaRPr lang="en-US" sz="14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ss spectrum of </a:t>
                      </a:r>
                      <a:r>
                        <a:rPr lang="en-US" sz="1400" i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β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oxidation of SVA 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9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btained in orbitrap mass spectrometer</a:t>
                      </a:r>
                      <a:endParaRPr lang="en-US" sz="1400" dirty="0">
                        <a:solidFill>
                          <a:srgbClr val="00B050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ass spectrum of SVA 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8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obtained in orbitrap mass spectrometer</a:t>
                      </a:r>
                      <a:endParaRPr lang="en-US" sz="1400" dirty="0">
                        <a:solidFill>
                          <a:srgbClr val="00B050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ss spectrum of DMHB 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11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btained in orbitrap mass spectrometer (urine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95820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66254" y="307677"/>
            <a:ext cx="864523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re are six possible hydroxylation sites indicated below, and the mass of the possible hydroxylated product is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35.27472 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 i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35.27412 [M+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ith mass accuracy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.4 ppm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3" name="Picture 2"/>
          <p:cNvPicPr/>
          <p:nvPr/>
        </p:nvPicPr>
        <p:blipFill rotWithShape="1">
          <a:blip r:embed="rId3"/>
          <a:srcRect b="1023"/>
          <a:stretch/>
        </p:blipFill>
        <p:spPr bwMode="auto">
          <a:xfrm>
            <a:off x="498142" y="1391914"/>
            <a:ext cx="7981460" cy="4720504"/>
          </a:xfrm>
          <a:prstGeom prst="rect">
            <a:avLst/>
          </a:prstGeom>
          <a:noFill/>
          <a:ln>
            <a:noFill/>
          </a:ln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</p:pic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5990849"/>
              </p:ext>
            </p:extLst>
          </p:nvPr>
        </p:nvGraphicFramePr>
        <p:xfrm>
          <a:off x="5759739" y="3134085"/>
          <a:ext cx="2030413" cy="1584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549" name="CS ChemDraw Drawing" r:id="rId4" imgW="1535040" imgH="1192680" progId="ChemDraw.Document.6.0">
                  <p:embed/>
                </p:oleObj>
              </mc:Choice>
              <mc:Fallback>
                <p:oleObj name="CS ChemDraw Drawing" r:id="rId4" imgW="1535040" imgH="119268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759739" y="3134085"/>
                        <a:ext cx="2030413" cy="158432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 Box 29"/>
          <p:cNvSpPr txBox="1"/>
          <p:nvPr/>
        </p:nvSpPr>
        <p:spPr>
          <a:xfrm>
            <a:off x="5442557" y="4942119"/>
            <a:ext cx="2347595" cy="652145"/>
          </a:xfrm>
          <a:prstGeom prst="rect">
            <a:avLst/>
          </a:prstGeom>
          <a:solidFill>
            <a:schemeClr val="lt1"/>
          </a:solidFill>
          <a:ln w="6350">
            <a:solidFill>
              <a:schemeClr val="bg1"/>
            </a:solidFill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indent="18034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sible oxidation sites</a:t>
            </a:r>
            <a:endParaRPr lang="en-US" sz="13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 indent="180340" algn="ct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hydroxylation/dihydroxylation)</a:t>
            </a:r>
            <a:endParaRPr lang="en-US" sz="13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 indent="18034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3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 indent="18034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3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  <a:p>
            <a:pPr marL="0" marR="0" indent="18034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3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 </a:t>
            </a:r>
          </a:p>
        </p:txBody>
      </p:sp>
      <p:sp>
        <p:nvSpPr>
          <p:cNvPr id="6" name="Rectangle 5"/>
          <p:cNvSpPr/>
          <p:nvPr/>
        </p:nvSpPr>
        <p:spPr>
          <a:xfrm>
            <a:off x="664398" y="6088659"/>
            <a:ext cx="811092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Figure S-7. Mass spectrum of SV-OH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obtained in orbitrap mass spectrometer.</a:t>
            </a:r>
            <a:endParaRPr lang="en-US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56021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55865" y="189821"/>
            <a:ext cx="854132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oxidative metabolite was observed in negative mode, with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375.25300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375.25299 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ith mass accuracy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0.8 ppm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3" name="Picture 2"/>
          <p:cNvPicPr/>
          <p:nvPr/>
        </p:nvPicPr>
        <p:blipFill rotWithShape="1">
          <a:blip r:embed="rId2"/>
          <a:srcRect l="1" r="40991"/>
          <a:stretch/>
        </p:blipFill>
        <p:spPr bwMode="auto">
          <a:xfrm>
            <a:off x="1005149" y="1384818"/>
            <a:ext cx="4857032" cy="4880899"/>
          </a:xfrm>
          <a:prstGeom prst="rect">
            <a:avLst/>
          </a:prstGeom>
          <a:noFill/>
          <a:ln>
            <a:noFill/>
          </a:ln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</p:pic>
      <p:grpSp>
        <p:nvGrpSpPr>
          <p:cNvPr id="4" name="Group 3"/>
          <p:cNvGrpSpPr/>
          <p:nvPr/>
        </p:nvGrpSpPr>
        <p:grpSpPr>
          <a:xfrm>
            <a:off x="2334513" y="2962891"/>
            <a:ext cx="1749425" cy="1907540"/>
            <a:chOff x="0" y="0"/>
            <a:chExt cx="1749716" cy="1907883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6171"/>
            <a:stretch/>
          </p:blipFill>
          <p:spPr bwMode="auto">
            <a:xfrm>
              <a:off x="49427" y="0"/>
              <a:ext cx="1561465" cy="150622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6" name="Text Box 26"/>
            <p:cNvSpPr txBox="1"/>
            <p:nvPr/>
          </p:nvSpPr>
          <p:spPr>
            <a:xfrm>
              <a:off x="0" y="1581665"/>
              <a:ext cx="1749716" cy="326218"/>
            </a:xfrm>
            <a:prstGeom prst="rect">
              <a:avLst/>
            </a:prstGeom>
            <a:solidFill>
              <a:schemeClr val="lt1"/>
            </a:solidFill>
            <a:ln w="6350">
              <a:solidFill>
                <a:schemeClr val="bg1"/>
              </a:solidFill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indent="180340" algn="just">
                <a:lnSpc>
                  <a:spcPct val="200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sz="1200" i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β</a:t>
              </a:r>
              <a:r>
                <a:rPr lang="en-US" sz="120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oxidation of SVA</a:t>
              </a:r>
              <a:endParaRPr lang="en-US" sz="1300">
                <a:effectLst/>
                <a:latin typeface="Times New Roman" panose="02020603050405020304" pitchFamily="18" charset="0"/>
                <a:ea typeface="Calibri" panose="020F0502020204030204" pitchFamily="34" charset="0"/>
              </a:endParaRPr>
            </a:p>
          </p:txBody>
        </p:sp>
      </p:grpSp>
      <p:sp>
        <p:nvSpPr>
          <p:cNvPr id="7" name="Rectangle 6"/>
          <p:cNvSpPr/>
          <p:nvPr/>
        </p:nvSpPr>
        <p:spPr>
          <a:xfrm>
            <a:off x="155865" y="6046913"/>
            <a:ext cx="877977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8. Mass spectrum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β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oxidation of SVA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9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btained in orbitrap mass spectrometer.  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73881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15637" y="425117"/>
            <a:ext cx="832311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SVA, a possible hydrolyzed reaction product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is also observed in negative mode with accurate mass of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= 435.27454 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= 435.27412 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and with mass accuracy of 1.0 ppm.</a:t>
            </a:r>
            <a:endParaRPr lang="en-US" dirty="0"/>
          </a:p>
        </p:txBody>
      </p:sp>
      <p:pic>
        <p:nvPicPr>
          <p:cNvPr id="3" name="Picture 2"/>
          <p:cNvPicPr/>
          <p:nvPr/>
        </p:nvPicPr>
        <p:blipFill rotWithShape="1">
          <a:blip r:embed="rId2"/>
          <a:srcRect r="23679"/>
          <a:stretch/>
        </p:blipFill>
        <p:spPr bwMode="auto">
          <a:xfrm>
            <a:off x="922569" y="1348447"/>
            <a:ext cx="6768412" cy="5067935"/>
          </a:xfrm>
          <a:prstGeom prst="rect">
            <a:avLst/>
          </a:prstGeom>
          <a:noFill/>
          <a:ln>
            <a:noFill/>
          </a:ln>
          <a:effectLst/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4010" y="2879581"/>
            <a:ext cx="1517015" cy="1285875"/>
          </a:xfrm>
          <a:prstGeom prst="rect">
            <a:avLst/>
          </a:prstGeom>
          <a:noFill/>
        </p:spPr>
      </p:pic>
      <p:sp>
        <p:nvSpPr>
          <p:cNvPr id="5" name="Rectangle 4"/>
          <p:cNvSpPr/>
          <p:nvPr/>
        </p:nvSpPr>
        <p:spPr>
          <a:xfrm>
            <a:off x="502318" y="6352144"/>
            <a:ext cx="801303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Figure S-9. Mass spectrum of SVA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8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obtained in orbitrap mass spectrometer.</a:t>
            </a: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2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944471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84463" y="325179"/>
            <a:ext cx="829194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possible hydroxylation of the SV 2,2-dimethylbutyrul moiety at 3 position, after hydrolysis yielded a metabolic product namely ‘DMHB’ was observed in negative mode with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131.07019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131.07027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with mass accuracy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-0.6 ppm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08090" y="1705976"/>
            <a:ext cx="7044690" cy="43213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796481"/>
              </p:ext>
            </p:extLst>
          </p:nvPr>
        </p:nvGraphicFramePr>
        <p:xfrm>
          <a:off x="4193885" y="3389210"/>
          <a:ext cx="1593850" cy="1620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665" name="CS ChemDraw Drawing" r:id="rId4" imgW="677880" imgH="687960" progId="ChemDraw.Document.6.0">
                  <p:embed/>
                </p:oleObj>
              </mc:Choice>
              <mc:Fallback>
                <p:oleObj name="CS ChemDraw Drawing" r:id="rId4" imgW="677880" imgH="68796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93885" y="3389210"/>
                        <a:ext cx="1593850" cy="1620162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tangle 4"/>
          <p:cNvSpPr/>
          <p:nvPr/>
        </p:nvSpPr>
        <p:spPr>
          <a:xfrm>
            <a:off x="18593" y="5794402"/>
            <a:ext cx="9023684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180340"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0. Mass spectrum of DMHB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11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btained in orbitrap mass spectrometer (urine)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664081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94854" y="359631"/>
            <a:ext cx="8219209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possible hydrolyzed metabolic product namely ‘DMB’ also was observed in negative mode with the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115.07547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115.07536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with mass accuracy of 1.0 ppm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44379" y="5936420"/>
            <a:ext cx="8999621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1. Mass spectrum of DMB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10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btained in orbitrap mass spectrometer (Serum)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4" name="Picture 3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91711" y="1692262"/>
            <a:ext cx="7252856" cy="445896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3766837"/>
              </p:ext>
            </p:extLst>
          </p:nvPr>
        </p:nvGraphicFramePr>
        <p:xfrm>
          <a:off x="5533743" y="3349526"/>
          <a:ext cx="1552287" cy="150835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688" name="CS ChemDraw Drawing" r:id="rId4" imgW="677880" imgH="659160" progId="ChemDraw.Document.6.0">
                  <p:embed/>
                </p:oleObj>
              </mc:Choice>
              <mc:Fallback>
                <p:oleObj name="CS ChemDraw Drawing" r:id="rId4" imgW="677880" imgH="65916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33743" y="3349526"/>
                        <a:ext cx="1552287" cy="150835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93708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32509" y="376857"/>
            <a:ext cx="826077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glucuronide of DMB, namely ‘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lu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DMB’, also was observed in negative mode with the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91.10806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91.10744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with mass accuracy 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.1 ppm.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0" y="5794402"/>
            <a:ext cx="9068529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2. Mass spectrum of Glu-DMB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13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btained in orbitrap mass spectrometer (Urine)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4" name="Picture 3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32509" y="1432540"/>
            <a:ext cx="8021783" cy="45524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4660510"/>
              </p:ext>
            </p:extLst>
          </p:nvPr>
        </p:nvGraphicFramePr>
        <p:xfrm>
          <a:off x="4917955" y="3708783"/>
          <a:ext cx="2128005" cy="14693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711" name="CS ChemDraw Drawing" r:id="rId4" imgW="1269720" imgH="887400" progId="ChemDraw.Document.6.0">
                  <p:embed/>
                </p:oleObj>
              </mc:Choice>
              <mc:Fallback>
                <p:oleObj name="CS ChemDraw Drawing" r:id="rId4" imgW="1269720" imgH="88740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917955" y="3708783"/>
                        <a:ext cx="2128005" cy="1469336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77844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342900" y="317791"/>
            <a:ext cx="8323118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A possible hydrolyzed and glycine conjugation metabolic product namely ‘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gly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DMB’ also was observed in negative mode with the accurate mass at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=172.09688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(exact mass: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=172.09682[M-H]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and with mass accuracy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of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0.3 ppm.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0" y="6099409"/>
            <a:ext cx="9144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Figure S-13. Mass spectrum of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Gly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-DMB (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M12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) obtained in orbitrap mass spectrometer (Urine)</a:t>
            </a:r>
            <a:endParaRPr lang="en-US" dirty="0"/>
          </a:p>
        </p:txBody>
      </p:sp>
      <p:pic>
        <p:nvPicPr>
          <p:cNvPr id="4" name="Picture 3"/>
          <p:cNvPicPr/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74840" y="1662674"/>
            <a:ext cx="7408717" cy="45491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2024726"/>
              </p:ext>
            </p:extLst>
          </p:nvPr>
        </p:nvGraphicFramePr>
        <p:xfrm>
          <a:off x="5313949" y="3502116"/>
          <a:ext cx="1925828" cy="11728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4" name="CS ChemDraw Drawing" r:id="rId4" imgW="1063800" imgH="647640" progId="ChemDraw.Document.6.0">
                  <p:embed/>
                </p:oleObj>
              </mc:Choice>
              <mc:Fallback>
                <p:oleObj name="CS ChemDraw Drawing" r:id="rId4" imgW="1063800" imgH="647640" progId="ChemDraw.Document.6.0">
                  <p:embed/>
                  <p:pic>
                    <p:nvPicPr>
                      <p:cNvPr id="0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13949" y="3502116"/>
                        <a:ext cx="1925828" cy="117287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903400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705365-1471-4DA8-A755-1969C8F798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7</a:t>
            </a:fld>
            <a:endParaRPr lang="en-US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2B67231-5313-40F4-9AC3-7E21FD79FE87}"/>
              </a:ext>
            </a:extLst>
          </p:cNvPr>
          <p:cNvGrpSpPr/>
          <p:nvPr/>
        </p:nvGrpSpPr>
        <p:grpSpPr>
          <a:xfrm>
            <a:off x="1366284" y="552892"/>
            <a:ext cx="5943600" cy="5267539"/>
            <a:chOff x="0" y="1471843"/>
            <a:chExt cx="5943600" cy="5267997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548521F-C104-4D1B-82F2-67099B3CC96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3285"/>
            <a:stretch/>
          </p:blipFill>
          <p:spPr bwMode="auto">
            <a:xfrm>
              <a:off x="0" y="1471843"/>
              <a:ext cx="5943600" cy="2950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830C85D-1988-4220-86F9-893AED0CE2F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7584"/>
            <a:stretch/>
          </p:blipFill>
          <p:spPr bwMode="auto">
            <a:xfrm>
              <a:off x="0" y="4421994"/>
              <a:ext cx="5943600" cy="23178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6">
              <a:extLst>
                <a:ext uri="{FF2B5EF4-FFF2-40B4-BE49-F238E27FC236}">
                  <a16:creationId xmlns:a16="http://schemas.microsoft.com/office/drawing/2014/main" id="{39EEA186-A3FB-4361-A973-5745DA54B227}"/>
                </a:ext>
              </a:extLst>
            </p:cNvPr>
            <p:cNvSpPr txBox="1"/>
            <p:nvPr/>
          </p:nvSpPr>
          <p:spPr>
            <a:xfrm>
              <a:off x="1944322" y="2295838"/>
              <a:ext cx="914400" cy="321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[M+H]</a:t>
              </a:r>
              <a:r>
                <a:rPr lang="en-US" sz="1200" kern="1200" baseline="300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+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90B1567A-CE64-4DAF-BC86-A7F3CE4D7980}"/>
                </a:ext>
              </a:extLst>
            </p:cNvPr>
            <p:cNvCxnSpPr/>
            <p:nvPr/>
          </p:nvCxnSpPr>
          <p:spPr>
            <a:xfrm flipH="1">
              <a:off x="1607046" y="2434537"/>
              <a:ext cx="337276" cy="276999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F4AEC401-5572-4F55-84DF-1590B13FBD3F}"/>
                </a:ext>
              </a:extLst>
            </p:cNvPr>
            <p:cNvCxnSpPr/>
            <p:nvPr/>
          </p:nvCxnSpPr>
          <p:spPr>
            <a:xfrm flipH="1">
              <a:off x="2771169" y="3205925"/>
              <a:ext cx="385688" cy="23168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9">
              <a:extLst>
                <a:ext uri="{FF2B5EF4-FFF2-40B4-BE49-F238E27FC236}">
                  <a16:creationId xmlns:a16="http://schemas.microsoft.com/office/drawing/2014/main" id="{86B2C33A-7F84-415A-B1C3-DEA6F832DB81}"/>
                </a:ext>
              </a:extLst>
            </p:cNvPr>
            <p:cNvSpPr txBox="1"/>
            <p:nvPr/>
          </p:nvSpPr>
          <p:spPr>
            <a:xfrm>
              <a:off x="3156857" y="3038572"/>
              <a:ext cx="774065" cy="321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[M+Na]</a:t>
              </a:r>
              <a:r>
                <a:rPr lang="en-US" sz="1200" kern="1200" baseline="300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+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2" name="TextBox 10">
              <a:extLst>
                <a:ext uri="{FF2B5EF4-FFF2-40B4-BE49-F238E27FC236}">
                  <a16:creationId xmlns:a16="http://schemas.microsoft.com/office/drawing/2014/main" id="{68D6F4FB-ECC9-49C6-86DB-2AD74C4B5451}"/>
                </a:ext>
              </a:extLst>
            </p:cNvPr>
            <p:cNvSpPr txBox="1"/>
            <p:nvPr/>
          </p:nvSpPr>
          <p:spPr>
            <a:xfrm>
              <a:off x="4025802" y="3250588"/>
              <a:ext cx="914400" cy="3219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[M+K]</a:t>
              </a:r>
              <a:r>
                <a:rPr lang="en-US" sz="1200" kern="1200" baseline="300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+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7F3A77A2-FF9F-4FE6-9E51-0D5336BD9706}"/>
                </a:ext>
              </a:extLst>
            </p:cNvPr>
            <p:cNvCxnSpPr/>
            <p:nvPr/>
          </p:nvCxnSpPr>
          <p:spPr>
            <a:xfrm flipH="1">
              <a:off x="3555163" y="3474306"/>
              <a:ext cx="425414" cy="26896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8">
              <a:extLst>
                <a:ext uri="{FF2B5EF4-FFF2-40B4-BE49-F238E27FC236}">
                  <a16:creationId xmlns:a16="http://schemas.microsoft.com/office/drawing/2014/main" id="{27FD2BEE-6A70-4EBB-8180-EC92218D7170}"/>
                </a:ext>
              </a:extLst>
            </p:cNvPr>
            <p:cNvSpPr txBox="1"/>
            <p:nvPr/>
          </p:nvSpPr>
          <p:spPr>
            <a:xfrm>
              <a:off x="355167" y="1558157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" name="TextBox 19">
              <a:extLst>
                <a:ext uri="{FF2B5EF4-FFF2-40B4-BE49-F238E27FC236}">
                  <a16:creationId xmlns:a16="http://schemas.microsoft.com/office/drawing/2014/main" id="{7FC0424F-2F20-4D43-8361-89E58E60B268}"/>
                </a:ext>
              </a:extLst>
            </p:cNvPr>
            <p:cNvSpPr txBox="1"/>
            <p:nvPr/>
          </p:nvSpPr>
          <p:spPr>
            <a:xfrm>
              <a:off x="355167" y="4525091"/>
              <a:ext cx="280035" cy="308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400" kern="1200" dirty="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B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" name="TextBox 26">
              <a:extLst>
                <a:ext uri="{FF2B5EF4-FFF2-40B4-BE49-F238E27FC236}">
                  <a16:creationId xmlns:a16="http://schemas.microsoft.com/office/drawing/2014/main" id="{6AD69A87-AED4-40C3-ACE5-BF78F26C7B6A}"/>
                </a:ext>
              </a:extLst>
            </p:cNvPr>
            <p:cNvSpPr txBox="1"/>
            <p:nvPr/>
          </p:nvSpPr>
          <p:spPr>
            <a:xfrm>
              <a:off x="3185327" y="3802970"/>
              <a:ext cx="516890" cy="2082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algn="r">
                <a:spcBef>
                  <a:spcPts val="0"/>
                </a:spcBef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457.1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8" name="TextBox 26">
              <a:extLst>
                <a:ext uri="{FF2B5EF4-FFF2-40B4-BE49-F238E27FC236}">
                  <a16:creationId xmlns:a16="http://schemas.microsoft.com/office/drawing/2014/main" id="{F3F54608-6C83-4D4B-A544-FB325EB3FF54}"/>
                </a:ext>
              </a:extLst>
            </p:cNvPr>
            <p:cNvSpPr txBox="1"/>
            <p:nvPr/>
          </p:nvSpPr>
          <p:spPr>
            <a:xfrm>
              <a:off x="2342017" y="3442946"/>
              <a:ext cx="516890" cy="2082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algn="r">
                <a:spcBef>
                  <a:spcPts val="0"/>
                </a:spcBef>
                <a:spcAft>
                  <a:spcPts val="0"/>
                </a:spcAft>
              </a:pPr>
              <a:r>
                <a:rPr lang="en-US" sz="8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444.1</a:t>
              </a:r>
              <a:endParaRPr lang="en-US" sz="120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9" name="TextBox 26">
              <a:extLst>
                <a:ext uri="{FF2B5EF4-FFF2-40B4-BE49-F238E27FC236}">
                  <a16:creationId xmlns:a16="http://schemas.microsoft.com/office/drawing/2014/main" id="{5B4A1588-3E4C-4F60-8489-59DA8780F2ED}"/>
                </a:ext>
              </a:extLst>
            </p:cNvPr>
            <p:cNvSpPr txBox="1"/>
            <p:nvPr/>
          </p:nvSpPr>
          <p:spPr>
            <a:xfrm>
              <a:off x="1258979" y="1568790"/>
              <a:ext cx="516255" cy="20828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marL="0" marR="0" algn="r">
                <a:spcBef>
                  <a:spcPts val="0"/>
                </a:spcBef>
                <a:spcAft>
                  <a:spcPts val="0"/>
                </a:spcAft>
              </a:pPr>
              <a:r>
                <a:rPr lang="en-US" sz="800" kern="1200" dirty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rPr>
                <a:t>419.1</a:t>
              </a:r>
              <a:endPara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  <p:sp>
        <p:nvSpPr>
          <p:cNvPr id="20" name="Rectangle 19">
            <a:extLst>
              <a:ext uri="{FF2B5EF4-FFF2-40B4-BE49-F238E27FC236}">
                <a16:creationId xmlns:a16="http://schemas.microsoft.com/office/drawing/2014/main" id="{9B7EC201-8BF8-40CC-9DCE-25652B003023}"/>
              </a:ext>
            </a:extLst>
          </p:cNvPr>
          <p:cNvSpPr/>
          <p:nvPr/>
        </p:nvSpPr>
        <p:spPr>
          <a:xfrm>
            <a:off x="338572" y="6012720"/>
            <a:ext cx="830010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4. LC-MS/MS spectra of SV: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SV in LC-MS positive mode; (B) LC-MS/MS spectrum of SV </a:t>
            </a:r>
          </a:p>
        </p:txBody>
      </p:sp>
    </p:spTree>
    <p:extLst>
      <p:ext uri="{BB962C8B-B14F-4D97-AF65-F5344CB8AC3E}">
        <p14:creationId xmlns:p14="http://schemas.microsoft.com/office/powerpoint/2010/main" val="367461957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3FF19B-583D-4F6D-B863-2D25B86E2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28</a:t>
            </a:fld>
            <a:endParaRPr lang="en-US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5BC2EEA-C668-4F33-AC5E-932536149CBA}"/>
              </a:ext>
            </a:extLst>
          </p:cNvPr>
          <p:cNvSpPr/>
          <p:nvPr/>
        </p:nvSpPr>
        <p:spPr>
          <a:xfrm>
            <a:off x="1265276" y="5869077"/>
            <a:ext cx="550247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5.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agmentation pattern of SV (</a:t>
            </a:r>
            <a:r>
              <a:rPr lang="en-US" sz="16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419[M+H]</a:t>
            </a:r>
            <a:r>
              <a:rPr lang="en-US" sz="16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US" sz="1600" baseline="30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65619013-299D-4BA7-8056-56294DC63F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8699334"/>
              </p:ext>
            </p:extLst>
          </p:nvPr>
        </p:nvGraphicFramePr>
        <p:xfrm>
          <a:off x="1265276" y="625393"/>
          <a:ext cx="6337003" cy="52436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9215" name="CS ChemDraw Drawing" r:id="rId3" imgW="5682690" imgH="4711910" progId="ChemDraw.Document.6.0">
                  <p:embed/>
                </p:oleObj>
              </mc:Choice>
              <mc:Fallback>
                <p:oleObj name="CS ChemDraw Drawing" r:id="rId3" imgW="5682690" imgH="4711910" progId="ChemDraw.Document.6.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65276" y="625393"/>
                        <a:ext cx="6337003" cy="524368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046239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47254" y="6084607"/>
            <a:ext cx="7793182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Low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6. SV was identified with </a:t>
            </a:r>
            <a:r>
              <a:rPr kumimoji="0" lang="en-US" altLang="en-US" sz="16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 419 [M+H]</a:t>
            </a:r>
            <a:r>
              <a:rPr kumimoji="0" lang="en-US" altLang="en-US" sz="16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ong with a sodium adduct at </a:t>
            </a:r>
            <a:r>
              <a:rPr kumimoji="0" lang="en-US" altLang="en-US" sz="16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 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 441[</a:t>
            </a:r>
            <a:r>
              <a:rPr kumimoji="0" lang="en-US" altLang="en-US" sz="16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kumimoji="0" lang="en-US" altLang="en-US" sz="16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iver (R</a:t>
            </a:r>
            <a:r>
              <a:rPr kumimoji="0" lang="en-US" altLang="en-US" sz="1600" b="0" i="1" u="none" strike="noStrike" cap="none" normalizeH="0" baseline="-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 </a:t>
            </a:r>
            <a:r>
              <a:rPr kumimoji="0" lang="en-US" altLang="en-US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 24.6 min.)</a:t>
            </a:r>
            <a:endParaRPr kumimoji="0" lang="en-US" altLang="en-US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472739" y="410403"/>
            <a:ext cx="6208221" cy="5674204"/>
            <a:chOff x="1497677" y="310960"/>
            <a:chExt cx="6208221" cy="5674204"/>
          </a:xfrm>
        </p:grpSpPr>
        <p:pic>
          <p:nvPicPr>
            <p:cNvPr id="11265" name="Picture 26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02"/>
            <a:stretch>
              <a:fillRect/>
            </a:stretch>
          </p:blipFill>
          <p:spPr bwMode="auto">
            <a:xfrm>
              <a:off x="1497677" y="310960"/>
              <a:ext cx="6208221" cy="460742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48392555"/>
                </p:ext>
              </p:extLst>
            </p:nvPr>
          </p:nvGraphicFramePr>
          <p:xfrm>
            <a:off x="2419233" y="515389"/>
            <a:ext cx="1244350" cy="11799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700" name="CS ChemDraw Drawing" r:id="rId4" imgW="1610467" imgH="1496242" progId="ChemDraw.Document.6.0">
                    <p:embed/>
                  </p:oleObj>
                </mc:Choice>
                <mc:Fallback>
                  <p:oleObj name="CS ChemDraw Drawing" r:id="rId4" imgW="1610467" imgH="1496242" progId="ChemDraw.Document.6.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19233" y="515389"/>
                          <a:ext cx="1244350" cy="1179988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08" t="24848" r="6745" b="63516"/>
            <a:stretch/>
          </p:blipFill>
          <p:spPr>
            <a:xfrm>
              <a:off x="1591776" y="4918384"/>
              <a:ext cx="6067302" cy="1066780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27</a:t>
            </a:r>
          </a:p>
        </p:txBody>
      </p:sp>
    </p:spTree>
    <p:extLst>
      <p:ext uri="{BB962C8B-B14F-4D97-AF65-F5344CB8AC3E}">
        <p14:creationId xmlns:p14="http://schemas.microsoft.com/office/powerpoint/2010/main" val="40044310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7821851"/>
              </p:ext>
            </p:extLst>
          </p:nvPr>
        </p:nvGraphicFramePr>
        <p:xfrm>
          <a:off x="443496" y="332801"/>
          <a:ext cx="8556125" cy="60235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169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76510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740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Entry</a:t>
                      </a:r>
                      <a:r>
                        <a:rPr lang="en-US" baseline="0" dirty="0"/>
                        <a:t> </a:t>
                      </a:r>
                      <a:endParaRPr lang="en-US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ntent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P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0542">
                <a:tc>
                  <a:txBody>
                    <a:bodyPr/>
                    <a:lstStyle/>
                    <a:p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1</a:t>
                      </a:r>
                      <a:endParaRPr lang="en-US" sz="1400" dirty="0">
                        <a:solidFill>
                          <a:srgbClr val="00B050"/>
                        </a:solidFill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ss spectrum of DMB </a:t>
                      </a:r>
                      <a:r>
                        <a:rPr lang="en-US" sz="16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</a:t>
                      </a:r>
                      <a:r>
                        <a:rPr lang="en-US" sz="16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10</a:t>
                      </a:r>
                      <a:r>
                        <a:rPr lang="en-US" sz="16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</a:t>
                      </a:r>
                      <a:r>
                        <a:rPr lang="en-US" sz="16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btained in orbitrap mass spectrometer (Serum)</a:t>
                      </a:r>
                      <a:endParaRPr lang="en-US" sz="18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ss spectrum of Glu-DMB 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13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obtained in orbitrap mass spectrometer (Urine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</a:t>
                      </a:r>
                      <a:endParaRPr kumimoji="0" lang="en-US" sz="1400" b="0" i="0" u="none" strike="noStrike" kern="1200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359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ass spectrum of </a:t>
                      </a:r>
                      <a:r>
                        <a:rPr lang="en-US" sz="1400" dirty="0" err="1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Gly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-DMB (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M12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) obtained in orbitrap mass spectrometer (Urine)</a:t>
                      </a:r>
                      <a:endParaRPr lang="en-US" sz="14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359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C-MS/MS spectra of 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</a:t>
                      </a:r>
                      <a:endParaRPr lang="en-US" sz="14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548576200"/>
                  </a:ext>
                </a:extLst>
              </a:tr>
              <a:tr h="373597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ation pattern of </a:t>
                      </a:r>
                      <a:r>
                        <a:rPr lang="en-US" sz="1400" b="1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V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268016044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6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 in Liver 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 in Heart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 in Kidney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60551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 in Lung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 in Serum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 in Urine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C-MS/MS spectra and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ation pattern 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1</a:t>
                      </a:r>
                      <a:endParaRPr lang="en-US" sz="1400" dirty="0"/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</a:t>
                      </a:r>
                      <a:endParaRPr kumimoji="0" lang="en-US" sz="1400" b="0" i="0" u="none" strike="noStrike" kern="1200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296963578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-OH </a:t>
                      </a: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 Heart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14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</a:t>
                      </a:r>
                      <a:endParaRPr kumimoji="0" lang="en-US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-OH </a:t>
                      </a: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 Lung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14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-OH </a:t>
                      </a: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 Lung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14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21488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-OH </a:t>
                      </a: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 Urine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0" lang="en-US" sz="1400" b="0" i="0" u="none" strike="noStrike" kern="1200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gure S-27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C-MS/MS spectra and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ation pattern 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2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>
          <a:xfrm>
            <a:off x="8073188" y="6356351"/>
            <a:ext cx="442161" cy="365125"/>
          </a:xfrm>
        </p:spPr>
        <p:txBody>
          <a:bodyPr/>
          <a:lstStyle/>
          <a:p>
            <a:fld id="{4701B916-522C-4F6F-9F58-8C8ABA027CD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00385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706581" y="6048019"/>
            <a:ext cx="754795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7. SV was identified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1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ong with a sodium adduct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1[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heart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4.6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597128" y="628898"/>
            <a:ext cx="7732225" cy="5396006"/>
            <a:chOff x="538939" y="348089"/>
            <a:chExt cx="7732225" cy="5396006"/>
          </a:xfrm>
        </p:grpSpPr>
        <p:pic>
          <p:nvPicPr>
            <p:cNvPr id="2" name="Picture 1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8939" y="348089"/>
              <a:ext cx="7732225" cy="4024406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48310683"/>
                </p:ext>
              </p:extLst>
            </p:nvPr>
          </p:nvGraphicFramePr>
          <p:xfrm>
            <a:off x="2443168" y="432261"/>
            <a:ext cx="1148862" cy="10894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842" name="CS ChemDraw Drawing" r:id="rId4" imgW="1610467" imgH="1496242" progId="ChemDraw.Document.6.0">
                    <p:embed/>
                  </p:oleObj>
                </mc:Choice>
                <mc:Fallback>
                  <p:oleObj name="CS ChemDraw Drawing" r:id="rId4" imgW="1610467" imgH="1496242" progId="ChemDraw.Document.6.0">
                    <p:embed/>
                    <p:pic>
                      <p:nvPicPr>
                        <p:cNvPr id="3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443168" y="432261"/>
                          <a:ext cx="1148862" cy="1089439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33" t="24848" r="6391" b="63152"/>
            <a:stretch/>
          </p:blipFill>
          <p:spPr>
            <a:xfrm>
              <a:off x="648392" y="4372495"/>
              <a:ext cx="7619990" cy="1371600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28</a:t>
            </a:r>
          </a:p>
        </p:txBody>
      </p:sp>
    </p:spTree>
    <p:extLst>
      <p:ext uri="{BB962C8B-B14F-4D97-AF65-F5344CB8AC3E}">
        <p14:creationId xmlns:p14="http://schemas.microsoft.com/office/powerpoint/2010/main" val="96441402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889461" y="6051665"/>
            <a:ext cx="7218755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8. SV was identified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1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ong with a sodium adduct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1[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kidney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4.4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889461" y="658414"/>
            <a:ext cx="7240386" cy="5393251"/>
            <a:chOff x="889461" y="658414"/>
            <a:chExt cx="7240386" cy="5393251"/>
          </a:xfrm>
        </p:grpSpPr>
        <p:pic>
          <p:nvPicPr>
            <p:cNvPr id="2" name="Picture 1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89462" y="658414"/>
              <a:ext cx="7240385" cy="3855397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85468691"/>
                </p:ext>
              </p:extLst>
            </p:nvPr>
          </p:nvGraphicFramePr>
          <p:xfrm>
            <a:off x="3100536" y="769022"/>
            <a:ext cx="1114018" cy="105639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9818" name="CS ChemDraw Drawing" r:id="rId4" imgW="1610467" imgH="1496242" progId="ChemDraw.Document.6.0">
                    <p:embed/>
                  </p:oleObj>
                </mc:Choice>
                <mc:Fallback>
                  <p:oleObj name="CS ChemDraw Drawing" r:id="rId4" imgW="1610467" imgH="1496242" progId="ChemDraw.Document.6.0">
                    <p:embed/>
                    <p:pic>
                      <p:nvPicPr>
                        <p:cNvPr id="3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100536" y="769022"/>
                          <a:ext cx="1114018" cy="1056397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61" t="24606" r="6706" b="63152"/>
            <a:stretch/>
          </p:blipFill>
          <p:spPr>
            <a:xfrm>
              <a:off x="889461" y="4711419"/>
              <a:ext cx="7218755" cy="1340246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29</a:t>
            </a:r>
          </a:p>
        </p:txBody>
      </p:sp>
    </p:spTree>
    <p:extLst>
      <p:ext uri="{BB962C8B-B14F-4D97-AF65-F5344CB8AC3E}">
        <p14:creationId xmlns:p14="http://schemas.microsoft.com/office/powerpoint/2010/main" val="626293084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740005" y="6044204"/>
            <a:ext cx="7464657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19. SV was identified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1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ong with a sodium adduct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1[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ung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4.8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440575" y="217650"/>
            <a:ext cx="7764087" cy="5826554"/>
            <a:chOff x="440575" y="217650"/>
            <a:chExt cx="7764087" cy="5826554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0575" y="217650"/>
              <a:ext cx="7764087" cy="4437478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61277151"/>
                </p:ext>
              </p:extLst>
            </p:nvPr>
          </p:nvGraphicFramePr>
          <p:xfrm>
            <a:off x="2846255" y="275839"/>
            <a:ext cx="1257360" cy="11923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8794" name="CS ChemDraw Drawing" r:id="rId4" imgW="1610467" imgH="1496242" progId="ChemDraw.Document.6.0">
                    <p:embed/>
                  </p:oleObj>
                </mc:Choice>
                <mc:Fallback>
                  <p:oleObj name="CS ChemDraw Drawing" r:id="rId4" imgW="1610467" imgH="1496242" progId="ChemDraw.Document.6.0">
                    <p:embed/>
                    <p:pic>
                      <p:nvPicPr>
                        <p:cNvPr id="3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846255" y="275839"/>
                          <a:ext cx="1257360" cy="1192325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76" t="24730" r="6419" b="63394"/>
            <a:stretch/>
          </p:blipFill>
          <p:spPr>
            <a:xfrm>
              <a:off x="449602" y="4655128"/>
              <a:ext cx="7755060" cy="1389076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30</a:t>
            </a:r>
          </a:p>
        </p:txBody>
      </p:sp>
    </p:spTree>
    <p:extLst>
      <p:ext uri="{BB962C8B-B14F-4D97-AF65-F5344CB8AC3E}">
        <p14:creationId xmlns:p14="http://schemas.microsoft.com/office/powerpoint/2010/main" val="4247473903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46534" y="6143105"/>
            <a:ext cx="7952509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20. SV was identified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1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ong with a sodium adduct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1[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serum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4.2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579466" y="355399"/>
            <a:ext cx="7608572" cy="5787706"/>
            <a:chOff x="122266" y="355399"/>
            <a:chExt cx="7608572" cy="5787706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2266" y="355399"/>
              <a:ext cx="7591946" cy="4424419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56622442"/>
                </p:ext>
              </p:extLst>
            </p:nvPr>
          </p:nvGraphicFramePr>
          <p:xfrm>
            <a:off x="2596075" y="355399"/>
            <a:ext cx="1161277" cy="1101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7770" name="CS ChemDraw Drawing" r:id="rId4" imgW="1610467" imgH="1496242" progId="ChemDraw.Document.6.0">
                    <p:embed/>
                  </p:oleObj>
                </mc:Choice>
                <mc:Fallback>
                  <p:oleObj name="CS ChemDraw Drawing" r:id="rId4" imgW="1610467" imgH="1496242" progId="ChemDraw.Document.6.0">
                    <p:embed/>
                    <p:pic>
                      <p:nvPicPr>
                        <p:cNvPr id="3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596075" y="355399"/>
                          <a:ext cx="1161277" cy="1101212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47" t="24727" r="6235" b="63273"/>
            <a:stretch/>
          </p:blipFill>
          <p:spPr>
            <a:xfrm>
              <a:off x="170792" y="4779818"/>
              <a:ext cx="7560046" cy="1363287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539836" y="6362755"/>
            <a:ext cx="2057400" cy="365125"/>
          </a:xfrm>
        </p:spPr>
        <p:txBody>
          <a:bodyPr/>
          <a:lstStyle/>
          <a:p>
            <a:r>
              <a:rPr lang="en-US" dirty="0"/>
              <a:t>31</a:t>
            </a:r>
          </a:p>
        </p:txBody>
      </p:sp>
    </p:spTree>
    <p:extLst>
      <p:ext uri="{BB962C8B-B14F-4D97-AF65-F5344CB8AC3E}">
        <p14:creationId xmlns:p14="http://schemas.microsoft.com/office/powerpoint/2010/main" val="203845151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871625" y="6054437"/>
            <a:ext cx="7392786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21. SV was identified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1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ong with a sodium adduct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1[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urine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3.3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871625" y="453404"/>
            <a:ext cx="7090786" cy="5531759"/>
            <a:chOff x="1031126" y="420153"/>
            <a:chExt cx="7090786" cy="5531759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31126" y="420153"/>
              <a:ext cx="7073784" cy="4259913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13139416"/>
                </p:ext>
              </p:extLst>
            </p:nvPr>
          </p:nvGraphicFramePr>
          <p:xfrm>
            <a:off x="4136751" y="507075"/>
            <a:ext cx="1033765" cy="98029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6746" name="CS ChemDraw Drawing" r:id="rId4" imgW="1610467" imgH="1496242" progId="ChemDraw.Document.6.0">
                    <p:embed/>
                  </p:oleObj>
                </mc:Choice>
                <mc:Fallback>
                  <p:oleObj name="CS ChemDraw Drawing" r:id="rId4" imgW="1610467" imgH="1496242" progId="ChemDraw.Document.6.0">
                    <p:embed/>
                    <p:pic>
                      <p:nvPicPr>
                        <p:cNvPr id="3" name="Object 2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4136751" y="507075"/>
                          <a:ext cx="1033765" cy="980295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47" t="24848" r="6392" b="63152"/>
            <a:stretch/>
          </p:blipFill>
          <p:spPr>
            <a:xfrm>
              <a:off x="1081798" y="4680065"/>
              <a:ext cx="7040114" cy="1271847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32</a:t>
            </a:r>
          </a:p>
        </p:txBody>
      </p:sp>
    </p:spTree>
    <p:extLst>
      <p:ext uri="{BB962C8B-B14F-4D97-AF65-F5344CB8AC3E}">
        <p14:creationId xmlns:p14="http://schemas.microsoft.com/office/powerpoint/2010/main" val="417723968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F5AD2E-C564-4FE1-8508-167F89363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35</a:t>
            </a:fld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FCD0560-8784-41D8-A206-074DFDABF44F}"/>
              </a:ext>
            </a:extLst>
          </p:cNvPr>
          <p:cNvSpPr/>
          <p:nvPr/>
        </p:nvSpPr>
        <p:spPr>
          <a:xfrm>
            <a:off x="285410" y="6174692"/>
            <a:ext cx="885859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22. LC-MS/MS spectra and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gmentation pattern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1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1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ossible SV metabolites) a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19 in positive mode; and (B) possible fragmentation pattern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A6EDC4-229B-42A5-8724-B067F1432671}"/>
              </a:ext>
            </a:extLst>
          </p:cNvPr>
          <p:cNvSpPr txBox="1"/>
          <p:nvPr/>
        </p:nvSpPr>
        <p:spPr>
          <a:xfrm>
            <a:off x="2364707" y="222760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C93D26EE-C8FB-4AA9-A4E4-B60EF49CF9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7779111"/>
              </p:ext>
            </p:extLst>
          </p:nvPr>
        </p:nvGraphicFramePr>
        <p:xfrm>
          <a:off x="2364707" y="2227606"/>
          <a:ext cx="3960896" cy="39470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8412" name="CS ChemDraw Drawing" r:id="rId3" imgW="4553402" imgH="4536544" progId="ChemDraw.Document.6.0">
                  <p:embed/>
                </p:oleObj>
              </mc:Choice>
              <mc:Fallback>
                <p:oleObj name="CS ChemDraw Drawing" r:id="rId3" imgW="4553402" imgH="453654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64707" y="2227606"/>
                        <a:ext cx="3960896" cy="39470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8">
            <a:extLst>
              <a:ext uri="{FF2B5EF4-FFF2-40B4-BE49-F238E27FC236}">
                <a16:creationId xmlns:a16="http://schemas.microsoft.com/office/drawing/2014/main" id="{D8436A84-3E9A-4B13-A8D9-2FB6FE2B757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4410" b="34214"/>
          <a:stretch/>
        </p:blipFill>
        <p:spPr>
          <a:xfrm>
            <a:off x="0" y="48322"/>
            <a:ext cx="9144000" cy="193708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B90C53F-50FC-46D9-99CE-779301922B6E}"/>
              </a:ext>
            </a:extLst>
          </p:cNvPr>
          <p:cNvSpPr txBox="1"/>
          <p:nvPr/>
        </p:nvSpPr>
        <p:spPr>
          <a:xfrm>
            <a:off x="653622" y="20625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74475111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76807" y="6194121"/>
            <a:ext cx="842599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23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ono-hydroxylated metabolites with </a:t>
            </a:r>
            <a:r>
              <a:rPr lang="en-US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435[M+H]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 heart (</a:t>
            </a:r>
            <a:r>
              <a:rPr lang="en-US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17.4 min).</a:t>
            </a:r>
            <a:endParaRPr lang="en-US" dirty="0"/>
          </a:p>
        </p:txBody>
      </p:sp>
      <p:grpSp>
        <p:nvGrpSpPr>
          <p:cNvPr id="5" name="Group 4"/>
          <p:cNvGrpSpPr/>
          <p:nvPr/>
        </p:nvGrpSpPr>
        <p:grpSpPr>
          <a:xfrm>
            <a:off x="756974" y="478118"/>
            <a:ext cx="7456057" cy="5716003"/>
            <a:chOff x="756974" y="478118"/>
            <a:chExt cx="7456057" cy="5716003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6974" y="478118"/>
              <a:ext cx="7456057" cy="4476267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91232221"/>
                </p:ext>
              </p:extLst>
            </p:nvPr>
          </p:nvGraphicFramePr>
          <p:xfrm>
            <a:off x="3105464" y="546518"/>
            <a:ext cx="1379538" cy="1173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5723" name="CS ChemDraw Drawing" r:id="rId4" imgW="1935206" imgH="1613663" progId="ChemDraw.Document.6.0">
                    <p:embed/>
                  </p:oleObj>
                </mc:Choice>
                <mc:Fallback>
                  <p:oleObj name="CS ChemDraw Drawing" r:id="rId4" imgW="1935206" imgH="1613663" progId="ChemDraw.Document.6.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105464" y="546518"/>
                          <a:ext cx="1379538" cy="1173163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16" t="24727" r="6737" b="63394"/>
            <a:stretch/>
          </p:blipFill>
          <p:spPr>
            <a:xfrm>
              <a:off x="809405" y="4874675"/>
              <a:ext cx="7351193" cy="1319446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33</a:t>
            </a:r>
          </a:p>
        </p:txBody>
      </p:sp>
    </p:spTree>
    <p:extLst>
      <p:ext uri="{BB962C8B-B14F-4D97-AF65-F5344CB8AC3E}">
        <p14:creationId xmlns:p14="http://schemas.microsoft.com/office/powerpoint/2010/main" val="141250582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15869" y="6202737"/>
            <a:ext cx="891089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Figure S-24. Mono-hydroxylated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etabolites with </a:t>
            </a:r>
            <a:r>
              <a:rPr lang="en-US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435[M+H]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 lung (</a:t>
            </a:r>
            <a:r>
              <a:rPr lang="en-US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17.4 min.) </a:t>
            </a:r>
            <a:endParaRPr lang="en-US" dirty="0"/>
          </a:p>
        </p:txBody>
      </p:sp>
      <p:grpSp>
        <p:nvGrpSpPr>
          <p:cNvPr id="6" name="Group 5"/>
          <p:cNvGrpSpPr/>
          <p:nvPr/>
        </p:nvGrpSpPr>
        <p:grpSpPr>
          <a:xfrm>
            <a:off x="551737" y="575100"/>
            <a:ext cx="7617989" cy="5551380"/>
            <a:chOff x="551737" y="575100"/>
            <a:chExt cx="7617989" cy="5551380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1737" y="575100"/>
              <a:ext cx="7617989" cy="4163154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009251996"/>
                </p:ext>
              </p:extLst>
            </p:nvPr>
          </p:nvGraphicFramePr>
          <p:xfrm>
            <a:off x="2158234" y="575100"/>
            <a:ext cx="1379538" cy="1173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4937" name="CS ChemDraw Drawing" r:id="rId4" imgW="1935206" imgH="1613663" progId="ChemDraw.Document.6.0">
                    <p:embed/>
                  </p:oleObj>
                </mc:Choice>
                <mc:Fallback>
                  <p:oleObj name="CS ChemDraw Drawing" r:id="rId4" imgW="1935206" imgH="1613663" progId="ChemDraw.Document.6.0">
                    <p:embed/>
                    <p:pic>
                      <p:nvPicPr>
                        <p:cNvPr id="6" name="Object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158234" y="575100"/>
                          <a:ext cx="1379538" cy="1173163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04" t="24727" r="6549" b="63030"/>
            <a:stretch/>
          </p:blipFill>
          <p:spPr>
            <a:xfrm>
              <a:off x="664573" y="4738254"/>
              <a:ext cx="7504662" cy="1388226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676314" y="6452182"/>
            <a:ext cx="2057400" cy="365125"/>
          </a:xfrm>
        </p:spPr>
        <p:txBody>
          <a:bodyPr/>
          <a:lstStyle/>
          <a:p>
            <a:r>
              <a:rPr lang="en-US" dirty="0"/>
              <a:t>34</a:t>
            </a:r>
          </a:p>
        </p:txBody>
      </p:sp>
    </p:spTree>
    <p:extLst>
      <p:ext uri="{BB962C8B-B14F-4D97-AF65-F5344CB8AC3E}">
        <p14:creationId xmlns:p14="http://schemas.microsoft.com/office/powerpoint/2010/main" val="261844313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37136" y="6014741"/>
            <a:ext cx="7625715" cy="509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25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no-hydroxylated metabolites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35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ung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1.8 min.) 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494801" y="437459"/>
            <a:ext cx="7506393" cy="5717953"/>
            <a:chOff x="494801" y="437459"/>
            <a:chExt cx="7506393" cy="5717953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4801" y="437459"/>
              <a:ext cx="7506393" cy="4342359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53439183"/>
                </p:ext>
              </p:extLst>
            </p:nvPr>
          </p:nvGraphicFramePr>
          <p:xfrm>
            <a:off x="2668954" y="499219"/>
            <a:ext cx="1379538" cy="1173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3913" name="CS ChemDraw Drawing" r:id="rId4" imgW="1935206" imgH="1613663" progId="ChemDraw.Document.6.0">
                    <p:embed/>
                  </p:oleObj>
                </mc:Choice>
                <mc:Fallback>
                  <p:oleObj name="CS ChemDraw Drawing" r:id="rId4" imgW="1935206" imgH="1613663" progId="ChemDraw.Document.6.0">
                    <p:embed/>
                    <p:pic>
                      <p:nvPicPr>
                        <p:cNvPr id="6" name="Object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668954" y="499219"/>
                          <a:ext cx="1379538" cy="1173163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04" t="24727" r="6549" b="63030"/>
            <a:stretch/>
          </p:blipFill>
          <p:spPr>
            <a:xfrm>
              <a:off x="564821" y="4779818"/>
              <a:ext cx="7436373" cy="1375594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35</a:t>
            </a:r>
          </a:p>
        </p:txBody>
      </p:sp>
    </p:spTree>
    <p:extLst>
      <p:ext uri="{BB962C8B-B14F-4D97-AF65-F5344CB8AC3E}">
        <p14:creationId xmlns:p14="http://schemas.microsoft.com/office/powerpoint/2010/main" val="550186264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58758" y="6163190"/>
            <a:ext cx="83265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26. 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ono-hydroxylated metabolites with </a:t>
            </a:r>
            <a:r>
              <a:rPr lang="en-US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435[M+H]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 urine (</a:t>
            </a:r>
            <a:r>
              <a:rPr lang="en-US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17.4 min.)</a:t>
            </a:r>
            <a:endParaRPr lang="en-US" dirty="0"/>
          </a:p>
        </p:txBody>
      </p:sp>
      <p:grpSp>
        <p:nvGrpSpPr>
          <p:cNvPr id="6" name="Group 5"/>
          <p:cNvGrpSpPr/>
          <p:nvPr/>
        </p:nvGrpSpPr>
        <p:grpSpPr>
          <a:xfrm>
            <a:off x="748146" y="386446"/>
            <a:ext cx="7456516" cy="5776744"/>
            <a:chOff x="706582" y="246268"/>
            <a:chExt cx="7456516" cy="5776744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06582" y="246268"/>
              <a:ext cx="7456516" cy="4417174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05218476"/>
                </p:ext>
              </p:extLst>
            </p:nvPr>
          </p:nvGraphicFramePr>
          <p:xfrm>
            <a:off x="3510851" y="246268"/>
            <a:ext cx="1379538" cy="11731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889" name="CS ChemDraw Drawing" r:id="rId4" imgW="1935206" imgH="1613663" progId="ChemDraw.Document.6.0">
                    <p:embed/>
                  </p:oleObj>
                </mc:Choice>
                <mc:Fallback>
                  <p:oleObj name="CS ChemDraw Drawing" r:id="rId4" imgW="1935206" imgH="1613663" progId="ChemDraw.Document.6.0">
                    <p:embed/>
                    <p:pic>
                      <p:nvPicPr>
                        <p:cNvPr id="6" name="Object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10851" y="246268"/>
                          <a:ext cx="1379538" cy="1173163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47" t="24727" r="6549" b="62788"/>
            <a:stretch/>
          </p:blipFill>
          <p:spPr>
            <a:xfrm>
              <a:off x="818804" y="4640083"/>
              <a:ext cx="7344294" cy="1382929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727939" y="6349959"/>
            <a:ext cx="2057400" cy="365125"/>
          </a:xfrm>
        </p:spPr>
        <p:txBody>
          <a:bodyPr/>
          <a:lstStyle/>
          <a:p>
            <a:r>
              <a:rPr lang="en-US" dirty="0"/>
              <a:t>36</a:t>
            </a:r>
          </a:p>
        </p:txBody>
      </p:sp>
    </p:spTree>
    <p:extLst>
      <p:ext uri="{BB962C8B-B14F-4D97-AF65-F5344CB8AC3E}">
        <p14:creationId xmlns:p14="http://schemas.microsoft.com/office/powerpoint/2010/main" val="38293304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0253220"/>
              </p:ext>
            </p:extLst>
          </p:nvPr>
        </p:nvGraphicFramePr>
        <p:xfrm>
          <a:off x="469232" y="136525"/>
          <a:ext cx="8046118" cy="63167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598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595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2665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93416"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Entry 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Content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Pag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3416"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28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-(OH)2 in Hear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1</a:t>
                      </a:r>
                      <a:endParaRPr lang="en-US" sz="1400" kern="1200" noProof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268214184"/>
                  </a:ext>
                </a:extLst>
              </a:tr>
              <a:tr h="293416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29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-(OH)2 in Lung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908179373"/>
                  </a:ext>
                </a:extLst>
              </a:tr>
              <a:tr h="35209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0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V-(OH)2 in Urin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5209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1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C-MS/MS spectra and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ation pattern 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3</a:t>
                      </a:r>
                      <a:endParaRPr lang="en-US" sz="14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587989544"/>
                  </a:ext>
                </a:extLst>
              </a:tr>
              <a:tr h="293416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2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Dihydrodiol-SV in Heart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5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477014452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3</a:t>
                      </a:r>
                    </a:p>
                  </a:txBody>
                  <a:tcPr>
                    <a:lnT w="12700" cmpd="sng"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err="1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Dihydrodiol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-SV in Lung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6</a:t>
                      </a:r>
                      <a:endParaRPr lang="en-US" sz="1400" kern="1200" noProof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4400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err="1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Dihydrodiol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-SV in Serum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7</a:t>
                      </a:r>
                      <a:endParaRPr lang="en-US" sz="1400" kern="1200" noProof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4400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C-MS/MS spectra and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ation pattern 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4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8</a:t>
                      </a:r>
                      <a:endParaRPr lang="en-US" sz="1400" kern="1200" noProof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99322060"/>
                  </a:ext>
                </a:extLst>
              </a:tr>
              <a:tr h="325385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err="1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Carboxymethyl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-SV in </a:t>
                      </a: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Kidney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49</a:t>
                      </a:r>
                      <a:endParaRPr lang="en-US" sz="1400" kern="1200" noProof="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err="1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Carboxymethyl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-SV Lung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+mn-cs"/>
                        </a:rPr>
                        <a:t>5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err="1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Carboxymethyl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-SV in </a:t>
                      </a:r>
                      <a:r>
                        <a:rPr lang="en-US" alt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Lung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+mn-cs"/>
                        </a:rPr>
                        <a:t>5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31991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3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err="1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Carboxymethyl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-SV Lung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+mn-cs"/>
                        </a:rPr>
                        <a:t>5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 err="1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Carboxymethyl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-SV Urine</a:t>
                      </a:r>
                      <a:endParaRPr lang="en-US" alt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+mn-cs"/>
                        </a:rPr>
                        <a:t>53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4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C-MS/MS spectra and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ation pattern </a:t>
                      </a: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7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54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312348396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4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SVA in Liver 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+mn-cs"/>
                        </a:rPr>
                        <a:t>5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4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SVA in Feces 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+mn-cs"/>
                        </a:rPr>
                        <a:t>5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4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C-MS/MS spectra of </a:t>
                      </a:r>
                      <a:r>
                        <a:rPr lang="en-US" sz="1400" b="1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8</a:t>
                      </a:r>
                      <a:endParaRPr lang="en-US" sz="1400" kern="1200" dirty="0">
                        <a:solidFill>
                          <a:schemeClr val="dk1"/>
                        </a:solidFill>
                        <a:latin typeface="Times New Roman" panose="02020603050405020304" pitchFamily="18" charset="0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5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118704608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4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  <a:sym typeface="Symbol" panose="05050102010706020507" pitchFamily="18" charset="2"/>
                        </a:rPr>
                        <a:t>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-Oxidized SVA in Liver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58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776347535"/>
                  </a:ext>
                </a:extLst>
              </a:tr>
              <a:tr h="29602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Figure S-46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C-MS/MS spectra and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agmentation pattern </a:t>
                      </a:r>
                      <a:r>
                        <a:rPr lang="en-US" sz="1400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of </a:t>
                      </a:r>
                      <a:r>
                        <a:rPr lang="en-US" sz="1400" b="1" kern="120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9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kern="1200" noProof="0" dirty="0">
                          <a:solidFill>
                            <a:schemeClr val="dk1"/>
                          </a:solidFill>
                          <a:latin typeface="Times New Roman" panose="02020603050405020304" pitchFamily="18" charset="0"/>
                          <a:ea typeface="Calibri" panose="020F0502020204030204" pitchFamily="34" charset="0"/>
                          <a:cs typeface="+mn-cs"/>
                        </a:rPr>
                        <a:t>59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858606901"/>
                  </a:ext>
                </a:extLst>
              </a:tr>
            </a:tbl>
          </a:graphicData>
        </a:graphic>
      </p:graphicFrame>
      <p:sp>
        <p:nvSpPr>
          <p:cNvPr id="3" name="Slide Number Placeholder 2"/>
          <p:cNvSpPr>
            <a:spLocks noGrp="1"/>
          </p:cNvSpPr>
          <p:nvPr>
            <p:ph type="sldNum" sz="quarter" idx="12"/>
          </p:nvPr>
        </p:nvSpPr>
        <p:spPr>
          <a:xfrm>
            <a:off x="6617368" y="6476447"/>
            <a:ext cx="2057400" cy="365125"/>
          </a:xfrm>
        </p:spPr>
        <p:txBody>
          <a:bodyPr/>
          <a:lstStyle/>
          <a:p>
            <a:fld id="{4701B916-522C-4F6F-9F58-8C8ABA027CD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667965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F5AD2E-C564-4FE1-8508-167F89363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40</a:t>
            </a:fld>
            <a:endParaRPr lang="en-US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1CD5AB50-0C64-4A06-BBE0-4FCF122AE1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3909401"/>
              </p:ext>
            </p:extLst>
          </p:nvPr>
        </p:nvGraphicFramePr>
        <p:xfrm>
          <a:off x="2295604" y="2138438"/>
          <a:ext cx="4552789" cy="40593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59" name="CS ChemDraw Drawing" r:id="rId3" imgW="6767593" imgH="6034868" progId="ChemDraw.Document.6.0">
                  <p:embed/>
                </p:oleObj>
              </mc:Choice>
              <mc:Fallback>
                <p:oleObj name="CS ChemDraw Drawing" r:id="rId3" imgW="6767593" imgH="603486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95604" y="2138438"/>
                        <a:ext cx="4552789" cy="40593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" name="Picture 4">
            <a:extLst>
              <a:ext uri="{FF2B5EF4-FFF2-40B4-BE49-F238E27FC236}">
                <a16:creationId xmlns:a16="http://schemas.microsoft.com/office/drawing/2014/main" id="{1E756438-25F9-42B2-A0F7-292A9E4B497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4587" b="34414"/>
          <a:stretch/>
        </p:blipFill>
        <p:spPr>
          <a:xfrm>
            <a:off x="142704" y="136524"/>
            <a:ext cx="8858591" cy="1854124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7FCD0560-8784-41D8-A206-074DFDABF44F}"/>
              </a:ext>
            </a:extLst>
          </p:cNvPr>
          <p:cNvSpPr/>
          <p:nvPr/>
        </p:nvSpPr>
        <p:spPr>
          <a:xfrm>
            <a:off x="142703" y="6157131"/>
            <a:ext cx="885859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27. LC-MS/MS spectra and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gmentation pattern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2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ossible SV-OH) a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35 in positive mode; and (B) possible fragmentation pattern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B90C53F-50FC-46D9-99CE-779301922B6E}"/>
              </a:ext>
            </a:extLst>
          </p:cNvPr>
          <p:cNvSpPr txBox="1"/>
          <p:nvPr/>
        </p:nvSpPr>
        <p:spPr>
          <a:xfrm>
            <a:off x="729165" y="23223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A6EDC4-229B-42A5-8724-B067F1432671}"/>
              </a:ext>
            </a:extLst>
          </p:cNvPr>
          <p:cNvSpPr txBox="1"/>
          <p:nvPr/>
        </p:nvSpPr>
        <p:spPr>
          <a:xfrm>
            <a:off x="1753826" y="257712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557574286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202917" y="5971493"/>
            <a:ext cx="6805643" cy="7867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28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hydroxy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1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ong with a sodium adduct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73[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heart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0.7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900716" y="276093"/>
            <a:ext cx="6924502" cy="5811779"/>
            <a:chOff x="950592" y="406375"/>
            <a:chExt cx="6924502" cy="5811779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50592" y="406375"/>
              <a:ext cx="6924502" cy="3375916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87810144"/>
                </p:ext>
              </p:extLst>
            </p:nvPr>
          </p:nvGraphicFramePr>
          <p:xfrm>
            <a:off x="2900572" y="406375"/>
            <a:ext cx="1089537" cy="93652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1867" name="CS ChemDraw Drawing" r:id="rId4" imgW="1935206" imgH="1651454" progId="ChemDraw.Document.6.0">
                    <p:embed/>
                  </p:oleObj>
                </mc:Choice>
                <mc:Fallback>
                  <p:oleObj name="CS ChemDraw Drawing" r:id="rId4" imgW="1935206" imgH="1651454" progId="ChemDraw.Document.6.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900572" y="406375"/>
                          <a:ext cx="1089537" cy="936527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04" t="24727" r="6862" b="51880"/>
            <a:stretch/>
          </p:blipFill>
          <p:spPr>
            <a:xfrm>
              <a:off x="1009244" y="3782291"/>
              <a:ext cx="6865849" cy="2435863"/>
            </a:xfrm>
            <a:prstGeom prst="rect">
              <a:avLst/>
            </a:prstGeom>
          </p:spPr>
        </p:pic>
      </p:grpSp>
      <p:sp>
        <p:nvSpPr>
          <p:cNvPr id="8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37</a:t>
            </a:r>
          </a:p>
        </p:txBody>
      </p:sp>
    </p:spTree>
    <p:extLst>
      <p:ext uri="{BB962C8B-B14F-4D97-AF65-F5344CB8AC3E}">
        <p14:creationId xmlns:p14="http://schemas.microsoft.com/office/powerpoint/2010/main" val="1724237087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269077" y="5892974"/>
            <a:ext cx="6415695" cy="7867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29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hydroxy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1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ong with a sodium adduct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73[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ung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19.8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936568" y="236567"/>
            <a:ext cx="6681702" cy="5772785"/>
            <a:chOff x="919943" y="352945"/>
            <a:chExt cx="6681702" cy="5772785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19943" y="352945"/>
              <a:ext cx="6681702" cy="3497448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9656316"/>
                </p:ext>
              </p:extLst>
            </p:nvPr>
          </p:nvGraphicFramePr>
          <p:xfrm>
            <a:off x="3542690" y="352946"/>
            <a:ext cx="1120750" cy="9633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8009" name="CS ChemDraw Drawing" r:id="rId4" imgW="1935206" imgH="1651454" progId="ChemDraw.Document.6.0">
                    <p:embed/>
                  </p:oleObj>
                </mc:Choice>
                <mc:Fallback>
                  <p:oleObj name="CS ChemDraw Drawing" r:id="rId4" imgW="1935206" imgH="1651454" progId="ChemDraw.Document.6.0">
                    <p:embed/>
                    <p:pic>
                      <p:nvPicPr>
                        <p:cNvPr id="5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42690" y="352946"/>
                          <a:ext cx="1120750" cy="963356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61" t="24606" r="6392" b="52242"/>
            <a:stretch/>
          </p:blipFill>
          <p:spPr>
            <a:xfrm>
              <a:off x="1097279" y="3850393"/>
              <a:ext cx="6504366" cy="2275337"/>
            </a:xfrm>
            <a:prstGeom prst="rect">
              <a:avLst/>
            </a:prstGeom>
          </p:spPr>
        </p:pic>
      </p:grpSp>
      <p:sp>
        <p:nvSpPr>
          <p:cNvPr id="8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38</a:t>
            </a:r>
          </a:p>
        </p:txBody>
      </p:sp>
    </p:spTree>
    <p:extLst>
      <p:ext uri="{BB962C8B-B14F-4D97-AF65-F5344CB8AC3E}">
        <p14:creationId xmlns:p14="http://schemas.microsoft.com/office/powerpoint/2010/main" val="3509662474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080308" y="5832764"/>
            <a:ext cx="7273981" cy="7867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30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hydroxy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1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ong with a sodium adduct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73[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+Na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urine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17.8 min.)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681643" y="742240"/>
            <a:ext cx="7672647" cy="5090524"/>
            <a:chOff x="673331" y="551047"/>
            <a:chExt cx="7672647" cy="5090524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3331" y="551047"/>
              <a:ext cx="7672647" cy="3746633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62076251"/>
                </p:ext>
              </p:extLst>
            </p:nvPr>
          </p:nvGraphicFramePr>
          <p:xfrm>
            <a:off x="3701586" y="551047"/>
            <a:ext cx="1169672" cy="100540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6985" name="CS ChemDraw Drawing" r:id="rId4" imgW="1935206" imgH="1651454" progId="ChemDraw.Document.6.0">
                    <p:embed/>
                  </p:oleObj>
                </mc:Choice>
                <mc:Fallback>
                  <p:oleObj name="CS ChemDraw Drawing" r:id="rId4" imgW="1935206" imgH="1651454" progId="ChemDraw.Document.6.0">
                    <p:embed/>
                    <p:pic>
                      <p:nvPicPr>
                        <p:cNvPr id="5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701586" y="551047"/>
                          <a:ext cx="1169672" cy="1005408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47" t="24848" r="6549" b="63273"/>
            <a:stretch/>
          </p:blipFill>
          <p:spPr>
            <a:xfrm>
              <a:off x="759105" y="4297680"/>
              <a:ext cx="7501098" cy="1343891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39</a:t>
            </a:r>
          </a:p>
        </p:txBody>
      </p:sp>
    </p:spTree>
    <p:extLst>
      <p:ext uri="{BB962C8B-B14F-4D97-AF65-F5344CB8AC3E}">
        <p14:creationId xmlns:p14="http://schemas.microsoft.com/office/powerpoint/2010/main" val="3320488918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F5AD2E-C564-4FE1-8508-167F89363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44</a:t>
            </a:fld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FCD0560-8784-41D8-A206-074DFDABF44F}"/>
              </a:ext>
            </a:extLst>
          </p:cNvPr>
          <p:cNvSpPr/>
          <p:nvPr/>
        </p:nvSpPr>
        <p:spPr>
          <a:xfrm>
            <a:off x="302115" y="6136701"/>
            <a:ext cx="848093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31. LC-MS/MS spectra and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gmentation pattern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3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3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possible SV-(OH)</a:t>
            </a:r>
            <a:r>
              <a:rPr lang="en-US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] a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51 in positive mode; and (B) possible fragmentation pattern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A6EDC4-229B-42A5-8724-B067F1432671}"/>
              </a:ext>
            </a:extLst>
          </p:cNvPr>
          <p:cNvSpPr txBox="1"/>
          <p:nvPr/>
        </p:nvSpPr>
        <p:spPr>
          <a:xfrm>
            <a:off x="1433660" y="214697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727F4CB-657D-4075-A846-C02687F283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4414" b="33725"/>
          <a:stretch/>
        </p:blipFill>
        <p:spPr>
          <a:xfrm>
            <a:off x="142704" y="136524"/>
            <a:ext cx="8858590" cy="190562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B90C53F-50FC-46D9-99CE-779301922B6E}"/>
              </a:ext>
            </a:extLst>
          </p:cNvPr>
          <p:cNvSpPr txBox="1"/>
          <p:nvPr/>
        </p:nvSpPr>
        <p:spPr>
          <a:xfrm>
            <a:off x="718190" y="27054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91EA6053-E6AC-48EF-A656-B24A7263118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1856907"/>
              </p:ext>
            </p:extLst>
          </p:nvPr>
        </p:nvGraphicFramePr>
        <p:xfrm>
          <a:off x="1630479" y="2146974"/>
          <a:ext cx="5921003" cy="39897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82" name="CS ChemDraw Drawing" r:id="rId4" imgW="6356113" imgH="4283670" progId="ChemDraw.Document.6.0">
                  <p:embed/>
                </p:oleObj>
              </mc:Choice>
              <mc:Fallback>
                <p:oleObj name="CS ChemDraw Drawing" r:id="rId4" imgW="6356113" imgH="4283670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30479" y="2146974"/>
                        <a:ext cx="5921003" cy="39897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01613151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548641" y="332056"/>
            <a:ext cx="7182195" cy="6437470"/>
            <a:chOff x="548641" y="332056"/>
            <a:chExt cx="7182195" cy="6437470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8641" y="332056"/>
              <a:ext cx="7182195" cy="359155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3" name="Rectangle 2"/>
            <p:cNvSpPr/>
            <p:nvPr/>
          </p:nvSpPr>
          <p:spPr>
            <a:xfrm>
              <a:off x="1002174" y="6352104"/>
              <a:ext cx="6495904" cy="41742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ure S-32. 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ihydrodiol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-SV at </a:t>
              </a:r>
              <a:r>
                <a:rPr lang="en-US" sz="1600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/z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=453[M+H]</a:t>
              </a:r>
              <a:r>
                <a:rPr lang="en-US" sz="1600" baseline="300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+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in heart (</a:t>
              </a:r>
              <a:r>
                <a:rPr lang="en-US" sz="16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</a:t>
              </a:r>
              <a:r>
                <a:rPr lang="en-US" sz="1600" i="1" baseline="-25000" dirty="0" err="1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t</a:t>
              </a:r>
              <a:r>
                <a:rPr lang="en-US" sz="1600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=26.5 min.).</a:t>
              </a:r>
              <a:endPara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endParaRPr>
            </a:p>
          </p:txBody>
        </p:sp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4490558"/>
                </p:ext>
              </p:extLst>
            </p:nvPr>
          </p:nvGraphicFramePr>
          <p:xfrm>
            <a:off x="3344617" y="398558"/>
            <a:ext cx="1061129" cy="90610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5963" name="CS ChemDraw Drawing" r:id="rId4" imgW="1972998" imgH="1718667" progId="ChemDraw.Document.6.0">
                    <p:embed/>
                  </p:oleObj>
                </mc:Choice>
                <mc:Fallback>
                  <p:oleObj name="CS ChemDraw Drawing" r:id="rId4" imgW="1972998" imgH="1718667" progId="ChemDraw.Document.6.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44617" y="398558"/>
                          <a:ext cx="1061129" cy="906105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65" t="24819" r="6745" b="52488"/>
            <a:stretch/>
          </p:blipFill>
          <p:spPr>
            <a:xfrm>
              <a:off x="769418" y="3923607"/>
              <a:ext cx="6961417" cy="2391398"/>
            </a:xfrm>
            <a:prstGeom prst="rect">
              <a:avLst/>
            </a:prstGeom>
          </p:spPr>
        </p:pic>
      </p:grpSp>
      <p:sp>
        <p:nvSpPr>
          <p:cNvPr id="8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0</a:t>
            </a:r>
          </a:p>
        </p:txBody>
      </p:sp>
    </p:spTree>
    <p:extLst>
      <p:ext uri="{BB962C8B-B14F-4D97-AF65-F5344CB8AC3E}">
        <p14:creationId xmlns:p14="http://schemas.microsoft.com/office/powerpoint/2010/main" val="2797650066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086023" y="5871782"/>
            <a:ext cx="6711315" cy="4174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33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hydrodio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3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ung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6.5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821400" y="767516"/>
            <a:ext cx="7115695" cy="5104266"/>
            <a:chOff x="856210" y="592949"/>
            <a:chExt cx="7115695" cy="5104266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56210" y="592949"/>
              <a:ext cx="7115695" cy="3821109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06809742"/>
                </p:ext>
              </p:extLst>
            </p:nvPr>
          </p:nvGraphicFramePr>
          <p:xfrm>
            <a:off x="3444257" y="592949"/>
            <a:ext cx="1235809" cy="105526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081" name="CS ChemDraw Drawing" r:id="rId4" imgW="1972998" imgH="1718667" progId="ChemDraw.Document.6.0">
                    <p:embed/>
                  </p:oleObj>
                </mc:Choice>
                <mc:Fallback>
                  <p:oleObj name="CS ChemDraw Drawing" r:id="rId4" imgW="1972998" imgH="1718667" progId="ChemDraw.Document.6.0">
                    <p:embed/>
                    <p:pic>
                      <p:nvPicPr>
                        <p:cNvPr id="5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444257" y="592949"/>
                          <a:ext cx="1235809" cy="1055266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90" t="24727" r="6391" b="63273"/>
            <a:stretch/>
          </p:blipFill>
          <p:spPr>
            <a:xfrm>
              <a:off x="856210" y="4414058"/>
              <a:ext cx="7115695" cy="1283157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1</a:t>
            </a:r>
          </a:p>
        </p:txBody>
      </p:sp>
    </p:spTree>
    <p:extLst>
      <p:ext uri="{BB962C8B-B14F-4D97-AF65-F5344CB8AC3E}">
        <p14:creationId xmlns:p14="http://schemas.microsoft.com/office/powerpoint/2010/main" val="3363285980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061259" y="5943601"/>
            <a:ext cx="6569825" cy="4174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34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hydrodio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at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53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serum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6.5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706358" y="704850"/>
            <a:ext cx="7431802" cy="5138998"/>
            <a:chOff x="681420" y="530282"/>
            <a:chExt cx="7431802" cy="5138998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1420" y="530282"/>
              <a:ext cx="7431802" cy="3742459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47806384"/>
                </p:ext>
              </p:extLst>
            </p:nvPr>
          </p:nvGraphicFramePr>
          <p:xfrm>
            <a:off x="3399300" y="530282"/>
            <a:ext cx="1155700" cy="987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0058" name="CS ChemDraw Drawing" r:id="rId4" imgW="1974742" imgH="1718801" progId="ChemDraw.Document.6.0">
                    <p:embed/>
                  </p:oleObj>
                </mc:Choice>
                <mc:Fallback>
                  <p:oleObj name="CS ChemDraw Drawing" r:id="rId4" imgW="1974742" imgH="1718801" progId="ChemDraw.Document.6.0">
                    <p:embed/>
                    <p:pic>
                      <p:nvPicPr>
                        <p:cNvPr id="5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99300" y="530282"/>
                          <a:ext cx="1155700" cy="987425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34" t="24848" r="6705" b="63394"/>
            <a:stretch/>
          </p:blipFill>
          <p:spPr>
            <a:xfrm>
              <a:off x="734241" y="4372494"/>
              <a:ext cx="7326160" cy="1296786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2</a:t>
            </a:r>
          </a:p>
        </p:txBody>
      </p:sp>
    </p:spTree>
    <p:extLst>
      <p:ext uri="{BB962C8B-B14F-4D97-AF65-F5344CB8AC3E}">
        <p14:creationId xmlns:p14="http://schemas.microsoft.com/office/powerpoint/2010/main" val="278999940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F5AD2E-C564-4FE1-8508-167F89363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48</a:t>
            </a:fld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FCD0560-8784-41D8-A206-074DFDABF44F}"/>
              </a:ext>
            </a:extLst>
          </p:cNvPr>
          <p:cNvSpPr/>
          <p:nvPr/>
        </p:nvSpPr>
        <p:spPr>
          <a:xfrm>
            <a:off x="142705" y="6236631"/>
            <a:ext cx="8110958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35. LC-MS/MS spectra and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gmentation pattern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4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4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hydrodiol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V] a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53 in positive mode; and (B) possible fragmentation pattern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A6EDC4-229B-42A5-8724-B067F1432671}"/>
              </a:ext>
            </a:extLst>
          </p:cNvPr>
          <p:cNvSpPr txBox="1"/>
          <p:nvPr/>
        </p:nvSpPr>
        <p:spPr>
          <a:xfrm>
            <a:off x="1500730" y="1495421"/>
            <a:ext cx="3403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2A48D66D-FBAD-4243-942E-80F566F461E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2660102"/>
              </p:ext>
            </p:extLst>
          </p:nvPr>
        </p:nvGraphicFramePr>
        <p:xfrm>
          <a:off x="1751952" y="1432049"/>
          <a:ext cx="5957811" cy="49243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302" name="CS ChemDraw Drawing" r:id="rId3" imgW="7814762" imgH="6459766" progId="ChemDraw.Document.6.0">
                  <p:embed/>
                </p:oleObj>
              </mc:Choice>
              <mc:Fallback>
                <p:oleObj name="CS ChemDraw Drawing" r:id="rId3" imgW="7814762" imgH="6459766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51952" y="1432049"/>
                        <a:ext cx="5957811" cy="49243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id="{565BE0BD-133D-4A4D-8339-E3701FB1879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5455" b="33725"/>
          <a:stretch/>
        </p:blipFill>
        <p:spPr>
          <a:xfrm>
            <a:off x="1160386" y="136524"/>
            <a:ext cx="6645349" cy="138282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B90C53F-50FC-46D9-99CE-779301922B6E}"/>
              </a:ext>
            </a:extLst>
          </p:cNvPr>
          <p:cNvSpPr txBox="1"/>
          <p:nvPr/>
        </p:nvSpPr>
        <p:spPr>
          <a:xfrm>
            <a:off x="1593094" y="1365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1107368459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870067" y="6148385"/>
            <a:ext cx="7043650" cy="509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36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boxymethy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kidney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0.1 min.)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576350" y="730850"/>
            <a:ext cx="7631084" cy="5162019"/>
            <a:chOff x="448888" y="523032"/>
            <a:chExt cx="7631084" cy="5162019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8888" y="523032"/>
              <a:ext cx="7631084" cy="3724771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98909750"/>
                </p:ext>
              </p:extLst>
            </p:nvPr>
          </p:nvGraphicFramePr>
          <p:xfrm>
            <a:off x="3345545" y="588677"/>
            <a:ext cx="1276331" cy="91627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9035" name="CS ChemDraw Drawing" r:id="rId4" imgW="2256706" imgH="1613663" progId="ChemDraw.Document.6.0">
                    <p:embed/>
                  </p:oleObj>
                </mc:Choice>
                <mc:Fallback>
                  <p:oleObj name="CS ChemDraw Drawing" r:id="rId4" imgW="2256706" imgH="1613663" progId="ChemDraw.Document.6.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345545" y="588677"/>
                          <a:ext cx="1276331" cy="916274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91" t="24848" r="6862" b="63152"/>
            <a:stretch/>
          </p:blipFill>
          <p:spPr>
            <a:xfrm>
              <a:off x="515390" y="4313449"/>
              <a:ext cx="7564582" cy="1371602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3</a:t>
            </a:r>
          </a:p>
        </p:txBody>
      </p:sp>
    </p:spTree>
    <p:extLst>
      <p:ext uri="{BB962C8B-B14F-4D97-AF65-F5344CB8AC3E}">
        <p14:creationId xmlns:p14="http://schemas.microsoft.com/office/powerpoint/2010/main" val="5481916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86503109"/>
              </p:ext>
            </p:extLst>
          </p:nvPr>
        </p:nvGraphicFramePr>
        <p:xfrm>
          <a:off x="304800" y="1696691"/>
          <a:ext cx="8243454" cy="434338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07782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8308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619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22057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45468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Group I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Control 1 (Red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Group 1a (Green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Group 1b (Blue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12227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Weight (g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90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196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205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42845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Amount  of SV added to the vehicles (g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None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0.1g/Kg </a:t>
                      </a:r>
                      <a:r>
                        <a:rPr lang="en-US" sz="1600">
                          <a:effectLst/>
                          <a:sym typeface="Symbol" panose="05050102010706020507" pitchFamily="18" charset="2"/>
                        </a:rPr>
                        <a:t></a:t>
                      </a:r>
                      <a:r>
                        <a:rPr lang="en-US" sz="1600">
                          <a:effectLst/>
                        </a:rPr>
                        <a:t> 0.196kg</a:t>
                      </a:r>
                    </a:p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= 0.0196g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0.1g/Kg </a:t>
                      </a:r>
                      <a:r>
                        <a:rPr lang="en-US" sz="1600">
                          <a:effectLst/>
                          <a:sym typeface="Symbol" panose="05050102010706020507" pitchFamily="18" charset="2"/>
                        </a:rPr>
                        <a:t></a:t>
                      </a:r>
                      <a:r>
                        <a:rPr lang="en-US" sz="1600">
                          <a:effectLst/>
                        </a:rPr>
                        <a:t> 0.205Kg</a:t>
                      </a:r>
                    </a:p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= 0.0205g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42845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Gavage Volume</a:t>
                      </a:r>
                    </a:p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of vehicle (mL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ml/Kg </a:t>
                      </a:r>
                      <a:r>
                        <a:rPr lang="en-US" sz="1600">
                          <a:effectLst/>
                          <a:sym typeface="Symbol" panose="05050102010706020507" pitchFamily="18" charset="2"/>
                        </a:rPr>
                        <a:t></a:t>
                      </a:r>
                      <a:r>
                        <a:rPr lang="en-US" sz="1600">
                          <a:effectLst/>
                        </a:rPr>
                        <a:t> 0.19 Kg</a:t>
                      </a:r>
                    </a:p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=0.95mL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mL/Kg</a:t>
                      </a:r>
                      <a:r>
                        <a:rPr lang="en-US" sz="1600">
                          <a:effectLst/>
                          <a:sym typeface="Symbol" panose="05050102010706020507" pitchFamily="18" charset="2"/>
                        </a:rPr>
                        <a:t></a:t>
                      </a:r>
                      <a:r>
                        <a:rPr lang="en-US" sz="1600">
                          <a:effectLst/>
                        </a:rPr>
                        <a:t>0.196 Kg</a:t>
                      </a:r>
                    </a:p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=0.98mL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5mL/Kg </a:t>
                      </a:r>
                      <a:r>
                        <a:rPr lang="en-US" sz="1600" dirty="0">
                          <a:effectLst/>
                          <a:sym typeface="Symbol" panose="05050102010706020507" pitchFamily="18" charset="2"/>
                        </a:rPr>
                        <a:t></a:t>
                      </a:r>
                      <a:r>
                        <a:rPr lang="en-US" sz="1600" dirty="0">
                          <a:effectLst/>
                        </a:rPr>
                        <a:t> 0.205 Kg</a:t>
                      </a:r>
                    </a:p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=1.025mL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487378" y="655396"/>
            <a:ext cx="7405338" cy="561949"/>
          </a:xfrm>
          <a:prstGeom prst="rect">
            <a:avLst/>
          </a:prstGeom>
          <a:extLst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en-US" b="1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Table S-1</a:t>
            </a:r>
            <a:r>
              <a:rPr lang="en-US" alt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. Amount of SV dosing for Group I</a:t>
            </a:r>
          </a:p>
        </p:txBody>
      </p:sp>
    </p:spTree>
    <p:extLst>
      <p:ext uri="{BB962C8B-B14F-4D97-AF65-F5344CB8AC3E}">
        <p14:creationId xmlns:p14="http://schemas.microsoft.com/office/powerpoint/2010/main" val="3922358344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030952" y="5885411"/>
            <a:ext cx="6965719" cy="509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37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boxymethy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ung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18.5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684761" y="577314"/>
            <a:ext cx="7447901" cy="5308097"/>
            <a:chOff x="684761" y="577314"/>
            <a:chExt cx="7447901" cy="5308097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4761" y="577314"/>
              <a:ext cx="7361959" cy="3928185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08594210"/>
                </p:ext>
              </p:extLst>
            </p:nvPr>
          </p:nvGraphicFramePr>
          <p:xfrm>
            <a:off x="3165213" y="577314"/>
            <a:ext cx="1413535" cy="101477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6201" name="CS ChemDraw Drawing" r:id="rId4" imgW="2256706" imgH="1613663" progId="ChemDraw.Document.6.0">
                    <p:embed/>
                  </p:oleObj>
                </mc:Choice>
                <mc:Fallback>
                  <p:oleObj name="CS ChemDraw Drawing" r:id="rId4" imgW="2256706" imgH="1613663" progId="ChemDraw.Document.6.0">
                    <p:embed/>
                    <p:pic>
                      <p:nvPicPr>
                        <p:cNvPr id="5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165213" y="577314"/>
                          <a:ext cx="1413535" cy="1014772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96" t="24625" r="6500" b="63011"/>
            <a:stretch/>
          </p:blipFill>
          <p:spPr>
            <a:xfrm>
              <a:off x="732553" y="4505499"/>
              <a:ext cx="7400109" cy="1379912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4</a:t>
            </a:r>
          </a:p>
        </p:txBody>
      </p:sp>
    </p:spTree>
    <p:extLst>
      <p:ext uri="{BB962C8B-B14F-4D97-AF65-F5344CB8AC3E}">
        <p14:creationId xmlns:p14="http://schemas.microsoft.com/office/powerpoint/2010/main" val="248551061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113907" y="6186401"/>
            <a:ext cx="6808122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38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Carboxymethy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SV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44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 lung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20.1 min.).</a:t>
            </a:r>
            <a:endParaRPr lang="en-US" sz="1600" dirty="0"/>
          </a:p>
        </p:txBody>
      </p:sp>
      <p:grpSp>
        <p:nvGrpSpPr>
          <p:cNvPr id="7" name="Group 6"/>
          <p:cNvGrpSpPr/>
          <p:nvPr/>
        </p:nvGrpSpPr>
        <p:grpSpPr>
          <a:xfrm>
            <a:off x="806334" y="382703"/>
            <a:ext cx="7398328" cy="5692620"/>
            <a:chOff x="806334" y="382703"/>
            <a:chExt cx="7398328" cy="5692620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6334" y="382703"/>
              <a:ext cx="7398327" cy="4372177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78692362"/>
                </p:ext>
              </p:extLst>
            </p:nvPr>
          </p:nvGraphicFramePr>
          <p:xfrm>
            <a:off x="3120160" y="382703"/>
            <a:ext cx="1576532" cy="11317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5177" name="CS ChemDraw Drawing" r:id="rId4" imgW="2256706" imgH="1613663" progId="ChemDraw.Document.6.0">
                    <p:embed/>
                  </p:oleObj>
                </mc:Choice>
                <mc:Fallback>
                  <p:oleObj name="CS ChemDraw Drawing" r:id="rId4" imgW="2256706" imgH="1613663" progId="ChemDraw.Document.6.0">
                    <p:embed/>
                    <p:pic>
                      <p:nvPicPr>
                        <p:cNvPr id="5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120160" y="382703"/>
                          <a:ext cx="1576532" cy="1131787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96" t="24625" r="6500" b="63011"/>
            <a:stretch/>
          </p:blipFill>
          <p:spPr>
            <a:xfrm>
              <a:off x="915434" y="4716087"/>
              <a:ext cx="7289228" cy="1359236"/>
            </a:xfrm>
            <a:prstGeom prst="rect">
              <a:avLst/>
            </a:prstGeom>
          </p:spPr>
        </p:pic>
      </p:grpSp>
      <p:sp>
        <p:nvSpPr>
          <p:cNvPr id="8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5</a:t>
            </a:r>
          </a:p>
        </p:txBody>
      </p:sp>
    </p:spTree>
    <p:extLst>
      <p:ext uri="{BB962C8B-B14F-4D97-AF65-F5344CB8AC3E}">
        <p14:creationId xmlns:p14="http://schemas.microsoft.com/office/powerpoint/2010/main" val="2368811733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793048" y="6010102"/>
            <a:ext cx="7370619" cy="5097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39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boxymethy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with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9[M+H]</a:t>
            </a:r>
            <a:r>
              <a:rPr lang="en-US" sz="16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ung (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sz="1600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1.6 min.).</a:t>
            </a:r>
            <a:endParaRPr lang="en-US" sz="16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623453" y="807755"/>
            <a:ext cx="7540214" cy="5293786"/>
            <a:chOff x="415635" y="483558"/>
            <a:chExt cx="7540214" cy="5293786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5635" y="483558"/>
              <a:ext cx="7540214" cy="3980377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44086327"/>
                </p:ext>
              </p:extLst>
            </p:nvPr>
          </p:nvGraphicFramePr>
          <p:xfrm>
            <a:off x="3048834" y="483558"/>
            <a:ext cx="1476929" cy="10602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4153" name="CS ChemDraw Drawing" r:id="rId4" imgW="2256706" imgH="1613663" progId="ChemDraw.Document.6.0">
                    <p:embed/>
                  </p:oleObj>
                </mc:Choice>
                <mc:Fallback>
                  <p:oleObj name="CS ChemDraw Drawing" r:id="rId4" imgW="2256706" imgH="1613663" progId="ChemDraw.Document.6.0">
                    <p:embed/>
                    <p:pic>
                      <p:nvPicPr>
                        <p:cNvPr id="5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048834" y="483558"/>
                          <a:ext cx="1476929" cy="1060282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96" t="24625" r="6500" b="63011"/>
            <a:stretch/>
          </p:blipFill>
          <p:spPr>
            <a:xfrm>
              <a:off x="415635" y="4380807"/>
              <a:ext cx="7489265" cy="1396537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6</a:t>
            </a:r>
          </a:p>
        </p:txBody>
      </p:sp>
    </p:spTree>
    <p:extLst>
      <p:ext uri="{BB962C8B-B14F-4D97-AF65-F5344CB8AC3E}">
        <p14:creationId xmlns:p14="http://schemas.microsoft.com/office/powerpoint/2010/main" val="2173514831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108365" y="6055185"/>
            <a:ext cx="7112924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40. </a:t>
            </a:r>
            <a:r>
              <a:rPr lang="en-US" sz="16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boxymethyl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V with </a:t>
            </a:r>
            <a:r>
              <a:rPr lang="en-US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49[M+H]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urine (</a:t>
            </a:r>
            <a:r>
              <a:rPr lang="en-US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16.6 min.).</a:t>
            </a:r>
            <a:endParaRPr lang="en-US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906090" y="617321"/>
            <a:ext cx="7090756" cy="5652737"/>
            <a:chOff x="1005840" y="459378"/>
            <a:chExt cx="7090756" cy="5652737"/>
          </a:xfrm>
        </p:grpSpPr>
        <p:pic>
          <p:nvPicPr>
            <p:cNvPr id="3" name="Picture 2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5840" y="459378"/>
              <a:ext cx="7090756" cy="4503320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46629325"/>
                </p:ext>
              </p:extLst>
            </p:nvPr>
          </p:nvGraphicFramePr>
          <p:xfrm>
            <a:off x="3467465" y="459378"/>
            <a:ext cx="1428732" cy="10256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3130" name="CS ChemDraw Drawing" r:id="rId4" imgW="2256706" imgH="1613663" progId="ChemDraw.Document.6.0">
                    <p:embed/>
                  </p:oleObj>
                </mc:Choice>
                <mc:Fallback>
                  <p:oleObj name="CS ChemDraw Drawing" r:id="rId4" imgW="2256706" imgH="1613663" progId="ChemDraw.Document.6.0">
                    <p:embed/>
                    <p:pic>
                      <p:nvPicPr>
                        <p:cNvPr id="5" name="Object 4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467465" y="459378"/>
                          <a:ext cx="1428732" cy="1025682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61" t="24849" r="6706" b="63515"/>
            <a:stretch/>
          </p:blipFill>
          <p:spPr>
            <a:xfrm>
              <a:off x="1206403" y="4896198"/>
              <a:ext cx="6890193" cy="1215917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7</a:t>
            </a:r>
          </a:p>
        </p:txBody>
      </p:sp>
    </p:spTree>
    <p:extLst>
      <p:ext uri="{BB962C8B-B14F-4D97-AF65-F5344CB8AC3E}">
        <p14:creationId xmlns:p14="http://schemas.microsoft.com/office/powerpoint/2010/main" val="2784655388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F5AD2E-C564-4FE1-8508-167F893632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54</a:t>
            </a:fld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FCD0560-8784-41D8-A206-074DFDABF44F}"/>
              </a:ext>
            </a:extLst>
          </p:cNvPr>
          <p:cNvSpPr/>
          <p:nvPr/>
        </p:nvSpPr>
        <p:spPr>
          <a:xfrm>
            <a:off x="0" y="6136701"/>
            <a:ext cx="885859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41. LC-MS/MS spectra and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gmentation pattern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7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7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Carboxymethyl-SV] a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49 in positive mode; and (B) possible fragmentation pattern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B90C53F-50FC-46D9-99CE-779301922B6E}"/>
              </a:ext>
            </a:extLst>
          </p:cNvPr>
          <p:cNvSpPr txBox="1"/>
          <p:nvPr/>
        </p:nvSpPr>
        <p:spPr>
          <a:xfrm>
            <a:off x="1759112" y="82401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3BB8AF8D-9FD9-4F54-86A6-1ABAE73FA55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5387" b="33933"/>
          <a:stretch/>
        </p:blipFill>
        <p:spPr>
          <a:xfrm>
            <a:off x="158090" y="136524"/>
            <a:ext cx="8272130" cy="1713499"/>
          </a:xfrm>
          <a:prstGeom prst="rect">
            <a:avLst/>
          </a:prstGeom>
        </p:spPr>
      </p:pic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9DEF8DC7-4A29-4FC9-B1B2-7CB0959B42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383094"/>
              </p:ext>
            </p:extLst>
          </p:nvPr>
        </p:nvGraphicFramePr>
        <p:xfrm>
          <a:off x="1064791" y="1846683"/>
          <a:ext cx="7014418" cy="42900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4323" name="CS ChemDraw Drawing" r:id="rId4" imgW="7938232" imgH="4855074" progId="ChemDraw.Document.6.0">
                  <p:embed/>
                </p:oleObj>
              </mc:Choice>
              <mc:Fallback>
                <p:oleObj name="CS ChemDraw Drawing" r:id="rId4" imgW="7938232" imgH="485507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64791" y="1846683"/>
                        <a:ext cx="7014418" cy="42900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26471128-3536-40E4-B538-E7EDAC6A4611}"/>
              </a:ext>
            </a:extLst>
          </p:cNvPr>
          <p:cNvSpPr txBox="1"/>
          <p:nvPr/>
        </p:nvSpPr>
        <p:spPr>
          <a:xfrm>
            <a:off x="705968" y="1573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8E541FC-930C-4718-807F-8CEF9AF92861}"/>
              </a:ext>
            </a:extLst>
          </p:cNvPr>
          <p:cNvSpPr txBox="1"/>
          <p:nvPr/>
        </p:nvSpPr>
        <p:spPr>
          <a:xfrm>
            <a:off x="1023684" y="195774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76829155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090303" y="5746512"/>
            <a:ext cx="5651675" cy="5619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42. 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VA at </a:t>
            </a:r>
            <a:r>
              <a:rPr lang="en-US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436[M-H]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iver (</a:t>
            </a:r>
            <a:r>
              <a:rPr lang="en-US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7.6 min.).</a:t>
            </a:r>
            <a:endParaRPr lang="en-US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1090303" y="905492"/>
            <a:ext cx="6876554" cy="4730536"/>
            <a:chOff x="764771" y="506482"/>
            <a:chExt cx="6876554" cy="4730536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771" y="506482"/>
              <a:ext cx="6816436" cy="3458689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6" name="Object 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0454042"/>
                </p:ext>
              </p:extLst>
            </p:nvPr>
          </p:nvGraphicFramePr>
          <p:xfrm>
            <a:off x="3504741" y="615140"/>
            <a:ext cx="1441331" cy="139162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2108" name="CS ChemDraw Drawing" r:id="rId4" imgW="1596700" imgH="1505420" progId="ChemDraw.Document.6.0">
                    <p:embed/>
                  </p:oleObj>
                </mc:Choice>
                <mc:Fallback>
                  <p:oleObj name="CS ChemDraw Drawing" r:id="rId4" imgW="1596700" imgH="1505420" progId="ChemDraw.Document.6.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504741" y="615140"/>
                          <a:ext cx="1441331" cy="1391629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76" t="24848" r="6392" b="63273"/>
            <a:stretch/>
          </p:blipFill>
          <p:spPr>
            <a:xfrm>
              <a:off x="914401" y="4040578"/>
              <a:ext cx="6726924" cy="1196440"/>
            </a:xfrm>
            <a:prstGeom prst="rect">
              <a:avLst/>
            </a:prstGeom>
          </p:spPr>
        </p:pic>
      </p:grpSp>
      <p:sp>
        <p:nvSpPr>
          <p:cNvPr id="8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8</a:t>
            </a:r>
          </a:p>
        </p:txBody>
      </p:sp>
    </p:spTree>
    <p:extLst>
      <p:ext uri="{BB962C8B-B14F-4D97-AF65-F5344CB8AC3E}">
        <p14:creationId xmlns:p14="http://schemas.microsoft.com/office/powerpoint/2010/main" val="2537612685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81049" y="5940960"/>
            <a:ext cx="56773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43. 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VA at </a:t>
            </a:r>
            <a:r>
              <a:rPr lang="en-US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m/z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436[M-H]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 feces (</a:t>
            </a:r>
            <a:r>
              <a:rPr lang="en-US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</a:t>
            </a:r>
            <a:r>
              <a:rPr lang="en-US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t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=7.6 min.).</a:t>
            </a:r>
            <a:endParaRPr lang="en-US" dirty="0"/>
          </a:p>
        </p:txBody>
      </p:sp>
      <p:grpSp>
        <p:nvGrpSpPr>
          <p:cNvPr id="6" name="Group 5"/>
          <p:cNvGrpSpPr/>
          <p:nvPr/>
        </p:nvGrpSpPr>
        <p:grpSpPr>
          <a:xfrm>
            <a:off x="981049" y="784222"/>
            <a:ext cx="7034282" cy="5009662"/>
            <a:chOff x="563551" y="750971"/>
            <a:chExt cx="7034282" cy="5009662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63551" y="750971"/>
              <a:ext cx="7034282" cy="3555022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37443283"/>
                </p:ext>
              </p:extLst>
            </p:nvPr>
          </p:nvGraphicFramePr>
          <p:xfrm>
            <a:off x="3819711" y="834098"/>
            <a:ext cx="1500435" cy="144869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8249" name="CS ChemDraw Drawing" r:id="rId4" imgW="1596700" imgH="1505420" progId="ChemDraw.Document.6.0">
                    <p:embed/>
                  </p:oleObj>
                </mc:Choice>
                <mc:Fallback>
                  <p:oleObj name="CS ChemDraw Drawing" r:id="rId4" imgW="1596700" imgH="1505420" progId="ChemDraw.Document.6.0">
                    <p:embed/>
                    <p:pic>
                      <p:nvPicPr>
                        <p:cNvPr id="6" name="Object 5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3819711" y="834098"/>
                          <a:ext cx="1500435" cy="1448696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61" t="24729" r="6392" b="63150"/>
            <a:stretch/>
          </p:blipFill>
          <p:spPr>
            <a:xfrm>
              <a:off x="640080" y="4486320"/>
              <a:ext cx="6957753" cy="1274313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49</a:t>
            </a:r>
          </a:p>
        </p:txBody>
      </p:sp>
    </p:spTree>
    <p:extLst>
      <p:ext uri="{BB962C8B-B14F-4D97-AF65-F5344CB8AC3E}">
        <p14:creationId xmlns:p14="http://schemas.microsoft.com/office/powerpoint/2010/main" val="1534977082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B6EC88-B450-4F3D-93F3-221F60181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57</a:t>
            </a:fld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616F2C6-F968-4D9C-9913-1D34E29BFC7A}"/>
              </a:ext>
            </a:extLst>
          </p:cNvPr>
          <p:cNvSpPr/>
          <p:nvPr/>
        </p:nvSpPr>
        <p:spPr>
          <a:xfrm>
            <a:off x="142705" y="6063963"/>
            <a:ext cx="885859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44. LC-MS/MS spectra and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gmentation pattern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f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8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8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SVA] a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35 in negative mode; and (B) possible fragmentation pattern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F2752A5-4181-4ADE-BA0E-2E80F1DD51A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4605" b="34020"/>
          <a:stretch/>
        </p:blipFill>
        <p:spPr>
          <a:xfrm>
            <a:off x="0" y="96515"/>
            <a:ext cx="9144000" cy="1937084"/>
          </a:xfrm>
          <a:prstGeom prst="rect">
            <a:avLst/>
          </a:prstGeom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4273AE9D-815D-458C-A0CB-AC8A6D38116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3091927"/>
              </p:ext>
            </p:extLst>
          </p:nvPr>
        </p:nvGraphicFramePr>
        <p:xfrm>
          <a:off x="2273300" y="2253249"/>
          <a:ext cx="4597400" cy="3443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5343" name="CS ChemDraw Drawing" r:id="rId4" imgW="4597314" imgH="3443622" progId="ChemDraw.Document.6.0">
                  <p:embed/>
                </p:oleObj>
              </mc:Choice>
              <mc:Fallback>
                <p:oleObj name="CS ChemDraw Drawing" r:id="rId4" imgW="4597314" imgH="3443622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73300" y="2253249"/>
                        <a:ext cx="4597400" cy="3443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08CADD94-8305-4949-AB11-1123D6438D4F}"/>
              </a:ext>
            </a:extLst>
          </p:cNvPr>
          <p:cNvSpPr txBox="1"/>
          <p:nvPr/>
        </p:nvSpPr>
        <p:spPr>
          <a:xfrm>
            <a:off x="609716" y="1365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96DB59B-5D13-408F-AD9E-026679F59830}"/>
              </a:ext>
            </a:extLst>
          </p:cNvPr>
          <p:cNvSpPr txBox="1"/>
          <p:nvPr/>
        </p:nvSpPr>
        <p:spPr>
          <a:xfrm>
            <a:off x="1955584" y="225324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63271662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931024" y="6049898"/>
            <a:ext cx="6511638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-45. </a:t>
            </a:r>
            <a:r>
              <a:rPr lang="en-US" sz="16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sym typeface="Symbol" panose="05050102010706020507" pitchFamily="18" charset="2"/>
              </a:rPr>
              <a:t></a:t>
            </a:r>
            <a:r>
              <a:rPr lang="en-US" sz="16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Oxidized SVA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t </a:t>
            </a:r>
            <a:r>
              <a:rPr lang="en-US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/z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375[M-H]</a:t>
            </a:r>
            <a:r>
              <a:rPr lang="en-US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liver (</a:t>
            </a:r>
            <a:r>
              <a:rPr lang="en-US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</a:t>
            </a:r>
            <a:r>
              <a:rPr lang="en-US" i="1" baseline="-25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=22.0 min.)</a:t>
            </a:r>
            <a:endParaRPr lang="en-US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931024" y="947886"/>
            <a:ext cx="7215447" cy="5051361"/>
            <a:chOff x="739833" y="443352"/>
            <a:chExt cx="7215447" cy="5051361"/>
          </a:xfrm>
        </p:grpSpPr>
        <p:pic>
          <p:nvPicPr>
            <p:cNvPr id="2" name="Picture 1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9833" y="443352"/>
              <a:ext cx="7215447" cy="3721324"/>
            </a:xfrm>
            <a:prstGeom prst="rect">
              <a:avLst/>
            </a:prstGeom>
            <a:noFill/>
            <a:ln>
              <a:noFill/>
            </a:ln>
          </p:spPr>
        </p:pic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87851870"/>
                </p:ext>
              </p:extLst>
            </p:nvPr>
          </p:nvGraphicFramePr>
          <p:xfrm>
            <a:off x="2094390" y="443352"/>
            <a:ext cx="1746090" cy="1650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7227" name="CS ChemDraw Drawing" r:id="rId4" imgW="1683621" imgH="1543480" progId="ChemDraw.Document.6.0">
                    <p:embed/>
                  </p:oleObj>
                </mc:Choice>
                <mc:Fallback>
                  <p:oleObj name="CS ChemDraw Drawing" r:id="rId4" imgW="1683621" imgH="1543480" progId="ChemDraw.Document.6.0">
                    <p:embed/>
                    <p:pic>
                      <p:nvPicPr>
                        <p:cNvPr id="0" name="Object 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094390" y="443352"/>
                          <a:ext cx="1746090" cy="1650687"/>
                        </a:xfrm>
                        <a:prstGeom prst="rect">
                          <a:avLst/>
                        </a:prstGeom>
                        <a:noFill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18" t="24848" r="6391" b="63469"/>
            <a:stretch/>
          </p:blipFill>
          <p:spPr>
            <a:xfrm>
              <a:off x="955962" y="4259891"/>
              <a:ext cx="6982607" cy="1234822"/>
            </a:xfrm>
            <a:prstGeom prst="rect">
              <a:avLst/>
            </a:prstGeom>
          </p:spPr>
        </p:pic>
      </p:grp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6457950" y="6356351"/>
            <a:ext cx="2057400" cy="365125"/>
          </a:xfrm>
        </p:spPr>
        <p:txBody>
          <a:bodyPr/>
          <a:lstStyle/>
          <a:p>
            <a:r>
              <a:rPr lang="en-US" dirty="0"/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2721305621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B6EC88-B450-4F3D-93F3-221F60181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1B916-522C-4F6F-9F58-8C8ABA027CD3}" type="slidenum">
              <a:rPr lang="en-US" smtClean="0"/>
              <a:t>59</a:t>
            </a:fld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616F2C6-F968-4D9C-9913-1D34E29BFC7A}"/>
              </a:ext>
            </a:extLst>
          </p:cNvPr>
          <p:cNvSpPr/>
          <p:nvPr/>
        </p:nvSpPr>
        <p:spPr>
          <a:xfrm>
            <a:off x="55416" y="5954138"/>
            <a:ext cx="8858590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-46. LC-MS/MS spectra and </a:t>
            </a:r>
            <a:r>
              <a:rPr lang="en-US" sz="16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ragmentation pattern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9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 spectra of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8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Beta-Oxidized-SVA] a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/z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375 in negative mode; and (B) possible fragmentation pattern 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8FFB2A1-3B0C-4978-8FB2-A18B52B3F67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0587611"/>
              </p:ext>
            </p:extLst>
          </p:nvPr>
        </p:nvGraphicFramePr>
        <p:xfrm>
          <a:off x="2483246" y="2014056"/>
          <a:ext cx="4177507" cy="39011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7391" name="CS ChemDraw Drawing" r:id="rId3" imgW="4583624" imgH="4280516" progId="ChemDraw.Document.6.0">
                  <p:embed/>
                </p:oleObj>
              </mc:Choice>
              <mc:Fallback>
                <p:oleObj name="CS ChemDraw Drawing" r:id="rId3" imgW="4583624" imgH="4280516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83246" y="2014056"/>
                        <a:ext cx="4177507" cy="39011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" name="Picture 2">
            <a:extLst>
              <a:ext uri="{FF2B5EF4-FFF2-40B4-BE49-F238E27FC236}">
                <a16:creationId xmlns:a16="http://schemas.microsoft.com/office/drawing/2014/main" id="{E51CC021-E5CA-4D48-AD13-AF0CAB1C849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34994" b="33435"/>
          <a:stretch/>
        </p:blipFill>
        <p:spPr>
          <a:xfrm>
            <a:off x="0" y="83343"/>
            <a:ext cx="9144000" cy="194911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7FA95B7-CDC3-4AA2-B88C-D5E88963371C}"/>
              </a:ext>
            </a:extLst>
          </p:cNvPr>
          <p:cNvSpPr txBox="1"/>
          <p:nvPr/>
        </p:nvSpPr>
        <p:spPr>
          <a:xfrm>
            <a:off x="609715" y="108633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67FC6FD-6574-464D-9C34-9A90CD1A11E2}"/>
              </a:ext>
            </a:extLst>
          </p:cNvPr>
          <p:cNvSpPr txBox="1"/>
          <p:nvPr/>
        </p:nvSpPr>
        <p:spPr>
          <a:xfrm>
            <a:off x="2324388" y="2169711"/>
            <a:ext cx="3177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5263017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79595" y="649037"/>
            <a:ext cx="8471900" cy="5619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kern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-2</a:t>
            </a:r>
            <a:r>
              <a:rPr lang="en-US" kern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ime of dosing, sacrificing and weight of rat models for Group I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09421611"/>
              </p:ext>
            </p:extLst>
          </p:nvPr>
        </p:nvGraphicFramePr>
        <p:xfrm>
          <a:off x="479595" y="1731948"/>
          <a:ext cx="8013241" cy="40300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5355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297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2256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955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451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3322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3322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90015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1721797">
                <a:tc>
                  <a:txBody>
                    <a:bodyPr/>
                    <a:lstStyle/>
                    <a:p>
                      <a:pPr marL="71755" marR="71755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Group I 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marL="71755" marR="71755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Time of dosing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marL="71755" marR="71755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Time of sacrificing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marL="71755" marR="71755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Brain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marL="71755" marR="71755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Heart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marL="71755" marR="71755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Lung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marL="71755" marR="71755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Liver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vert="vert270"/>
                </a:tc>
                <a:tc>
                  <a:txBody>
                    <a:bodyPr/>
                    <a:lstStyle/>
                    <a:p>
                      <a:pPr marL="71755" marR="71755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Kidney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vert="vert27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05265"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bg1"/>
                          </a:solidFill>
                          <a:effectLst/>
                        </a:rPr>
                        <a:t>Control 1</a:t>
                      </a:r>
                      <a:endParaRPr lang="en-US" sz="16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0:50 a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0.50 p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5990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0.7690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2860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7.8232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2.7899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05265"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bg1"/>
                          </a:solidFill>
                          <a:effectLst/>
                        </a:rPr>
                        <a:t>Group 1a</a:t>
                      </a:r>
                      <a:endParaRPr lang="en-US" sz="16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1:20 a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2:20 p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5999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0.7703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2863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7.8323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2.8160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97698"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Group 1b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1:50 a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2.50 p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.6112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0.7710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2868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7.8335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2.8353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704084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489721"/>
              </p:ext>
            </p:extLst>
          </p:nvPr>
        </p:nvGraphicFramePr>
        <p:xfrm>
          <a:off x="472786" y="1876146"/>
          <a:ext cx="7988300" cy="350865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437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753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01734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15183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01236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Group II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Control 2 (Blue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Group 2a (Red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Group2b (Orange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501236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Weight (g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194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220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198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03709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Amount  of SV added to the vehicles (g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None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0.1g/Kg x 0.220 kg</a:t>
                      </a: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= 0.0220g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0.1g/Kg x 0.198 Kg</a:t>
                      </a: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= 0.0198g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02473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Gavage Volume of vehicle (ml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5mL/Kg x 0.194 Kg</a:t>
                      </a: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= 0.97ml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5mL/Kg x 0.220 Kg</a:t>
                      </a: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= 1.1ml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5mL/Kg x 0.198 Kg</a:t>
                      </a: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= 0.99ml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585016" y="667988"/>
            <a:ext cx="6513615" cy="561949"/>
          </a:xfrm>
          <a:prstGeom prst="rect">
            <a:avLst/>
          </a:prstGeom>
          <a:extLst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en-US" b="1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Table S-3</a:t>
            </a:r>
            <a:r>
              <a:rPr lang="en-US" alt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. Amount of SV dosing for Group II</a:t>
            </a:r>
          </a:p>
        </p:txBody>
      </p:sp>
    </p:spTree>
    <p:extLst>
      <p:ext uri="{BB962C8B-B14F-4D97-AF65-F5344CB8AC3E}">
        <p14:creationId xmlns:p14="http://schemas.microsoft.com/office/powerpoint/2010/main" val="30309414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93870422"/>
              </p:ext>
            </p:extLst>
          </p:nvPr>
        </p:nvGraphicFramePr>
        <p:xfrm>
          <a:off x="329428" y="2039384"/>
          <a:ext cx="8482241" cy="352495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2253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180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78906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378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378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3786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3786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4753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129033"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Group II 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Time of dosing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Time of sacrificing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Brain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Heart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Lung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Liver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Kidney (g)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98641"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bg1"/>
                          </a:solidFill>
                          <a:effectLst/>
                        </a:rPr>
                        <a:t>Control 2</a:t>
                      </a:r>
                      <a:endParaRPr lang="en-US" sz="16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0:00a.m.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1:00a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.5996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0.7698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2862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7.8305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2.8320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98641"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bg1"/>
                          </a:solidFill>
                          <a:effectLst/>
                        </a:rPr>
                        <a:t>Group 2a</a:t>
                      </a:r>
                      <a:endParaRPr lang="en-US" sz="160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0:30a.m.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1:30a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6245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0.7718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2873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7.8342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2.8378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8641"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bg1"/>
                          </a:solidFill>
                          <a:effectLst/>
                        </a:rPr>
                        <a:t>Group 2b</a:t>
                      </a:r>
                      <a:endParaRPr lang="en-US" sz="1600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1:00a.m.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2:00p.m.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1.6015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0.7705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1.2866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solidFill>
                            <a:schemeClr val="tx1"/>
                          </a:solidFill>
                          <a:effectLst/>
                        </a:rPr>
                        <a:t>7.8334</a:t>
                      </a:r>
                      <a:endParaRPr lang="en-US" sz="16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just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effectLst/>
                        </a:rPr>
                        <a:t>2.8348</a:t>
                      </a:r>
                      <a:endParaRPr lang="en-US" sz="16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585823" y="480804"/>
            <a:ext cx="7969453" cy="561949"/>
          </a:xfrm>
          <a:prstGeom prst="rect">
            <a:avLst/>
          </a:prstGeom>
          <a:extLst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en-US" b="1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Table S-4</a:t>
            </a:r>
            <a:r>
              <a:rPr lang="en-US" altLang="en-US" kern="1600" dirty="0">
                <a:latin typeface="Times New Roman" panose="02020603050405020304" pitchFamily="18" charset="0"/>
                <a:ea typeface="ヒラギノ角ゴ Pro W3"/>
                <a:cs typeface="Times New Roman" panose="02020603050405020304" pitchFamily="18" charset="0"/>
              </a:rPr>
              <a:t>. Time of dosing, sacrificing and weight of rat models for Group II</a:t>
            </a:r>
          </a:p>
        </p:txBody>
      </p:sp>
    </p:spTree>
    <p:extLst>
      <p:ext uri="{BB962C8B-B14F-4D97-AF65-F5344CB8AC3E}">
        <p14:creationId xmlns:p14="http://schemas.microsoft.com/office/powerpoint/2010/main" val="9234387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5733259"/>
              </p:ext>
            </p:extLst>
          </p:nvPr>
        </p:nvGraphicFramePr>
        <p:xfrm>
          <a:off x="399829" y="443335"/>
          <a:ext cx="8343338" cy="62980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19323">
                  <a:extLst>
                    <a:ext uri="{9D8B030D-6E8A-4147-A177-3AD203B41FA5}">
                      <a16:colId xmlns:a16="http://schemas.microsoft.com/office/drawing/2014/main" val="4155113128"/>
                    </a:ext>
                  </a:extLst>
                </a:gridCol>
                <a:gridCol w="1475162">
                  <a:extLst>
                    <a:ext uri="{9D8B030D-6E8A-4147-A177-3AD203B41FA5}">
                      <a16:colId xmlns:a16="http://schemas.microsoft.com/office/drawing/2014/main" val="3693703009"/>
                    </a:ext>
                  </a:extLst>
                </a:gridCol>
                <a:gridCol w="1487060">
                  <a:extLst>
                    <a:ext uri="{9D8B030D-6E8A-4147-A177-3AD203B41FA5}">
                      <a16:colId xmlns:a16="http://schemas.microsoft.com/office/drawing/2014/main" val="2598995299"/>
                    </a:ext>
                  </a:extLst>
                </a:gridCol>
                <a:gridCol w="1619328">
                  <a:extLst>
                    <a:ext uri="{9D8B030D-6E8A-4147-A177-3AD203B41FA5}">
                      <a16:colId xmlns:a16="http://schemas.microsoft.com/office/drawing/2014/main" val="941987157"/>
                    </a:ext>
                  </a:extLst>
                </a:gridCol>
                <a:gridCol w="1513143">
                  <a:extLst>
                    <a:ext uri="{9D8B030D-6E8A-4147-A177-3AD203B41FA5}">
                      <a16:colId xmlns:a16="http://schemas.microsoft.com/office/drawing/2014/main" val="945170592"/>
                    </a:ext>
                  </a:extLst>
                </a:gridCol>
                <a:gridCol w="1429322">
                  <a:extLst>
                    <a:ext uri="{9D8B030D-6E8A-4147-A177-3AD203B41FA5}">
                      <a16:colId xmlns:a16="http://schemas.microsoft.com/office/drawing/2014/main" val="4273086152"/>
                    </a:ext>
                  </a:extLst>
                </a:gridCol>
              </a:tblGrid>
              <a:tr h="554168">
                <a:tc>
                  <a:txBody>
                    <a:bodyPr/>
                    <a:lstStyle/>
                    <a:p>
                      <a:pPr marL="71755" marR="71755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elected organs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etected</a:t>
                      </a:r>
                    </a:p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etabolites </a:t>
                      </a:r>
                    </a:p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(mode: +/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Molecular Formula</a:t>
                      </a:r>
                    </a:p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[M+H]</a:t>
                      </a:r>
                      <a:r>
                        <a:rPr lang="en-US" sz="1200" baseline="30000" dirty="0">
                          <a:effectLst/>
                        </a:rPr>
                        <a:t>+ </a:t>
                      </a:r>
                      <a:r>
                        <a:rPr lang="en-US" sz="1200" dirty="0">
                          <a:effectLst/>
                        </a:rPr>
                        <a:t>/ [M-H]</a:t>
                      </a:r>
                      <a:r>
                        <a:rPr lang="en-US" sz="1200" baseline="30000" dirty="0">
                          <a:effectLst/>
                        </a:rPr>
                        <a:t>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Exact Mass</a:t>
                      </a:r>
                    </a:p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(monoisotopic)</a:t>
                      </a:r>
                    </a:p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[M+H]</a:t>
                      </a:r>
                      <a:r>
                        <a:rPr lang="en-US" sz="1200" baseline="30000" dirty="0">
                          <a:effectLst/>
                        </a:rPr>
                        <a:t>+ </a:t>
                      </a:r>
                      <a:r>
                        <a:rPr lang="en-US" sz="1200" dirty="0">
                          <a:effectLst/>
                        </a:rPr>
                        <a:t>/ [M-H]</a:t>
                      </a:r>
                      <a:r>
                        <a:rPr lang="en-US" sz="1200" baseline="30000" dirty="0">
                          <a:effectLst/>
                        </a:rPr>
                        <a:t>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ccurate Mass</a:t>
                      </a:r>
                    </a:p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[M+H]</a:t>
                      </a:r>
                      <a:r>
                        <a:rPr lang="en-US" sz="1200" baseline="30000" dirty="0">
                          <a:effectLst/>
                        </a:rPr>
                        <a:t>+ </a:t>
                      </a:r>
                      <a:r>
                        <a:rPr lang="en-US" sz="1200" dirty="0">
                          <a:effectLst/>
                        </a:rPr>
                        <a:t>/ [M-H]</a:t>
                      </a:r>
                      <a:r>
                        <a:rPr lang="en-US" sz="1200" baseline="30000" dirty="0">
                          <a:effectLst/>
                        </a:rPr>
                        <a:t>-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Mass Accuracy</a:t>
                      </a:r>
                    </a:p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sym typeface="Symbol" panose="05050102010706020507" pitchFamily="18" charset="2"/>
                        </a:rPr>
                        <a:t></a:t>
                      </a:r>
                      <a:r>
                        <a:rPr lang="en-US" sz="1200">
                          <a:effectLst/>
                        </a:rPr>
                        <a:t> (&lt;5 ppm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extLst>
                  <a:ext uri="{0D108BD9-81ED-4DB2-BD59-A6C34878D82A}">
                    <a16:rowId xmlns:a16="http://schemas.microsoft.com/office/drawing/2014/main" val="2878103271"/>
                  </a:ext>
                </a:extLst>
              </a:tr>
              <a:tr h="184723">
                <a:tc rowSpan="3">
                  <a:txBody>
                    <a:bodyPr/>
                    <a:lstStyle/>
                    <a:p>
                      <a:pPr marL="71755" marR="71755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Liver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vert="vert27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educed SV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21.2948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21.2961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.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790605606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V-OH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</a:t>
                      </a:r>
                      <a:r>
                        <a:rPr lang="en-US" sz="1200" baseline="-25000" dirty="0">
                          <a:effectLst/>
                        </a:rPr>
                        <a:t>25</a:t>
                      </a:r>
                      <a:r>
                        <a:rPr lang="en-US" sz="1200" dirty="0">
                          <a:effectLst/>
                        </a:rPr>
                        <a:t>H</a:t>
                      </a:r>
                      <a:r>
                        <a:rPr lang="en-US" sz="1200" baseline="-25000" dirty="0">
                          <a:effectLst/>
                        </a:rPr>
                        <a:t>39</a:t>
                      </a:r>
                      <a:r>
                        <a:rPr lang="en-US" sz="1200" dirty="0">
                          <a:effectLst/>
                        </a:rPr>
                        <a:t>O</a:t>
                      </a:r>
                      <a:r>
                        <a:rPr lang="en-US" sz="1200" baseline="-25000" dirty="0">
                          <a:effectLst/>
                        </a:rPr>
                        <a:t>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4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20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4.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896337645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VA (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</a:t>
                      </a:r>
                      <a:r>
                        <a:rPr lang="en-US" sz="1200" baseline="-25000" dirty="0">
                          <a:effectLst/>
                        </a:rPr>
                        <a:t>25</a:t>
                      </a:r>
                      <a:r>
                        <a:rPr lang="en-US" sz="1200" dirty="0">
                          <a:effectLst/>
                        </a:rPr>
                        <a:t>H</a:t>
                      </a:r>
                      <a:r>
                        <a:rPr lang="en-US" sz="1200" baseline="-25000" dirty="0">
                          <a:effectLst/>
                        </a:rPr>
                        <a:t>39</a:t>
                      </a:r>
                      <a:r>
                        <a:rPr lang="en-US" sz="1200" dirty="0">
                          <a:effectLst/>
                        </a:rPr>
                        <a:t>O</a:t>
                      </a:r>
                      <a:r>
                        <a:rPr lang="en-US" sz="1200" baseline="-25000" dirty="0">
                          <a:effectLst/>
                        </a:rPr>
                        <a:t>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35.2741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37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0.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277395571"/>
                  </a:ext>
                </a:extLst>
              </a:tr>
              <a:tr h="184723">
                <a:tc rowSpan="10">
                  <a:txBody>
                    <a:bodyPr/>
                    <a:lstStyle/>
                    <a:p>
                      <a:pPr marL="71755" marR="71755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Heart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vert="vert27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V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19.2792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19.2787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1.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449030168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Exomethylene-SV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7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17.2635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17.2645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.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2986602769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educed SV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21.2948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21.2940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2.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344182329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arboxyl-SV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7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49.253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49.2540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992786599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V-OH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4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35.2749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889400300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ihydroxy-SV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1.2690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1.2694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0.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287728943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ihydrodiol-SV (+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3.2846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3.2832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3.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592864213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MB (-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1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15.0753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15.07531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0.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779486267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MHB (-)  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1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1.0702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1.0699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2.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4204496209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VA (-)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C</a:t>
                      </a:r>
                      <a:r>
                        <a:rPr lang="en-US" sz="1200" baseline="-25000" dirty="0">
                          <a:effectLst/>
                        </a:rPr>
                        <a:t>25</a:t>
                      </a:r>
                      <a:r>
                        <a:rPr lang="en-US" sz="1200" dirty="0">
                          <a:effectLst/>
                        </a:rPr>
                        <a:t>H</a:t>
                      </a:r>
                      <a:r>
                        <a:rPr lang="en-US" sz="1200" baseline="-25000" dirty="0">
                          <a:effectLst/>
                        </a:rPr>
                        <a:t>49</a:t>
                      </a:r>
                      <a:r>
                        <a:rPr lang="en-US" sz="1200" dirty="0">
                          <a:effectLst/>
                        </a:rPr>
                        <a:t>O</a:t>
                      </a:r>
                      <a:r>
                        <a:rPr lang="en-US" sz="1200" baseline="-25000" dirty="0">
                          <a:effectLst/>
                        </a:rPr>
                        <a:t>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35.2741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35.2738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0.6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320342211"/>
                  </a:ext>
                </a:extLst>
              </a:tr>
              <a:tr h="184723">
                <a:tc rowSpan="8">
                  <a:txBody>
                    <a:bodyPr/>
                    <a:lstStyle/>
                    <a:p>
                      <a:pPr marL="71755" marR="71755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Kidney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vert="vert27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educed SV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21.2948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21.2963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.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2619780030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ihydrodiol-SV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53.2846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3.2844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0.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2444683905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V-OH (+) 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4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50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.2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409286694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ihydroxy-SV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1.2690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1.2688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0.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613857430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MHB (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1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31.0702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1.06999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2.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009435413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lu-DMB (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12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1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91.10744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91.1073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0.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932215560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Gly-DMB (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8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14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3</a:t>
                      </a:r>
                      <a:r>
                        <a:rPr lang="en-US" sz="1200">
                          <a:effectLst/>
                        </a:rPr>
                        <a:t>N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72.0968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72.0968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0.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908918292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VA (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4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53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.8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786686513"/>
                  </a:ext>
                </a:extLst>
              </a:tr>
              <a:tr h="184723">
                <a:tc rowSpan="9">
                  <a:txBody>
                    <a:bodyPr/>
                    <a:lstStyle/>
                    <a:p>
                      <a:pPr marL="71755" marR="71755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Lung</a:t>
                      </a:r>
                      <a:endParaRPr lang="en-US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vert="vert27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V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19.2792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19.2787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1.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2067201519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Reduced SV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21.2948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21.2956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66367746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V-OH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4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20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4.7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886529632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ihydroxy-SV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1.2690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1.26965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4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314661232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ihydrodiol-SV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3.2846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53.2847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0.0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4211693837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arboxyl-SV (+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37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49.2533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49.2515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4.1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276142806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MB (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1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15.0753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15.07558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.9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164672916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DMHB (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11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3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1.07027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31.07010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-1.3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4041724229"/>
                  </a:ext>
                </a:extLst>
              </a:tr>
              <a:tr h="1847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SVA (-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C</a:t>
                      </a:r>
                      <a:r>
                        <a:rPr lang="en-US" sz="1200" baseline="-25000">
                          <a:effectLst/>
                        </a:rPr>
                        <a:t>25</a:t>
                      </a:r>
                      <a:r>
                        <a:rPr lang="en-US" sz="1200">
                          <a:effectLst/>
                        </a:rPr>
                        <a:t>H</a:t>
                      </a:r>
                      <a:r>
                        <a:rPr lang="en-US" sz="1200" baseline="-25000">
                          <a:effectLst/>
                        </a:rPr>
                        <a:t>49</a:t>
                      </a:r>
                      <a:r>
                        <a:rPr lang="en-US" sz="1200">
                          <a:effectLst/>
                        </a:rPr>
                        <a:t>O</a:t>
                      </a:r>
                      <a:r>
                        <a:rPr lang="en-US" sz="1200" baseline="-25000">
                          <a:effectLst/>
                        </a:rPr>
                        <a:t>6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41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 anchor="ctr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5.27432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1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0.5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43630" marR="43630" marT="0" marB="0"/>
                </a:tc>
                <a:extLst>
                  <a:ext uri="{0D108BD9-81ED-4DB2-BD59-A6C34878D82A}">
                    <a16:rowId xmlns:a16="http://schemas.microsoft.com/office/drawing/2014/main" val="3001082993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657617" y="46303"/>
            <a:ext cx="8085550" cy="3749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0000"/>
              </a:lnSpc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-5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Metabolites from selected pulverized organs in positive/negative mode</a:t>
            </a:r>
            <a:endParaRPr lang="en-US" sz="2000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8743167" y="6492876"/>
            <a:ext cx="400833" cy="365124"/>
          </a:xfrm>
        </p:spPr>
        <p:txBody>
          <a:bodyPr/>
          <a:lstStyle/>
          <a:p>
            <a:fld id="{4701B916-522C-4F6F-9F58-8C8ABA027CD3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6052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640</TotalTime>
  <Words>3660</Words>
  <Application>Microsoft Office PowerPoint</Application>
  <PresentationFormat>On-screen Show (4:3)</PresentationFormat>
  <Paragraphs>821</Paragraphs>
  <Slides>5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9</vt:i4>
      </vt:variant>
    </vt:vector>
  </HeadingPairs>
  <TitlesOfParts>
    <vt:vector size="67" baseType="lpstr">
      <vt:lpstr>Arial</vt:lpstr>
      <vt:lpstr>Calibri</vt:lpstr>
      <vt:lpstr>Calibri Light</vt:lpstr>
      <vt:lpstr>Symbol</vt:lpstr>
      <vt:lpstr>Times New Roman</vt:lpstr>
      <vt:lpstr>ヒラギノ角ゴ Pro W3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fm Motiur Rahman</dc:creator>
  <cp:lastModifiedBy>Mohammed Abid</cp:lastModifiedBy>
  <cp:revision>281</cp:revision>
  <dcterms:created xsi:type="dcterms:W3CDTF">2019-10-13T11:33:29Z</dcterms:created>
  <dcterms:modified xsi:type="dcterms:W3CDTF">2022-02-25T23:51:24Z</dcterms:modified>
</cp:coreProperties>
</file>